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theme/themeOverride1.xml" ContentType="application/vnd.openxmlformats-officedocument.themeOverride+xml"/>
  <Override PartName="/ppt/charts/chart6.xml" ContentType="application/vnd.openxmlformats-officedocument.drawingml.chart+xml"/>
  <Override PartName="/ppt/drawings/drawing1.xml" ContentType="application/vnd.openxmlformats-officedocument.drawingml.chartshapes+xml"/>
  <Override PartName="/ppt/charts/chart7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notesMasterIdLst>
    <p:notesMasterId r:id="rId10"/>
  </p:notesMasterIdLst>
  <p:handoutMasterIdLst>
    <p:handoutMasterId r:id="rId11"/>
  </p:handoutMasterIdLst>
  <p:sldIdLst>
    <p:sldId id="555" r:id="rId2"/>
    <p:sldId id="556" r:id="rId3"/>
    <p:sldId id="547" r:id="rId4"/>
    <p:sldId id="542" r:id="rId5"/>
    <p:sldId id="549" r:id="rId6"/>
    <p:sldId id="553" r:id="rId7"/>
    <p:sldId id="546" r:id="rId8"/>
    <p:sldId id="561" r:id="rId9"/>
  </p:sldIdLst>
  <p:sldSz cx="9144000" cy="6858000" type="screen4x3"/>
  <p:notesSz cx="6796088" cy="9928225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15100EA9-CE9A-4862-8935-BCF3DC0A400B}">
          <p14:sldIdLst/>
        </p14:section>
        <p14:section name="タイトルなしのセクション" id="{F08C7B7D-BBC4-4A68-8087-E24A981E09CC}">
          <p14:sldIdLst>
            <p14:sldId id="555"/>
            <p14:sldId id="556"/>
            <p14:sldId id="547"/>
            <p14:sldId id="542"/>
            <p14:sldId id="549"/>
            <p14:sldId id="553"/>
            <p14:sldId id="546"/>
            <p14:sldId id="56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CC00"/>
    <a:srgbClr val="66CCFF"/>
    <a:srgbClr val="FFFF00"/>
    <a:srgbClr val="FFFFFF"/>
    <a:srgbClr val="FF9900"/>
    <a:srgbClr val="FF3300"/>
    <a:srgbClr val="CC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735" autoAdjust="0"/>
    <p:restoredTop sz="93841" autoAdjust="0"/>
  </p:normalViewPr>
  <p:slideViewPr>
    <p:cSldViewPr>
      <p:cViewPr varScale="1">
        <p:scale>
          <a:sx n="55" d="100"/>
          <a:sy n="55" d="100"/>
        </p:scale>
        <p:origin x="1445" y="3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&#30740;&#31350;&#12289;&#22823;&#23398;&#38306;&#36899;\&#24111;&#24195;&#30044;&#29987;&#22823;&#23398;\&#24111;&#30044;&#22823;%20&#23455;&#39443;\&#31278;&#23376;&#20241;&#30496;&#12289;&#31298;&#30330;&#33469;\&#12458;&#12458;&#12512;&#12462;QSD1\&#30330;&#29694;&#35299;&#26512;&#12289;RT-PCR\151130%20new%20&#30330;&#29694;&#35299;&#26512;&#12288;&#20462;&#27491;&#12487;&#12540;&#12479;&#12288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&#30740;&#31350;&#12289;&#22823;&#23398;&#38306;&#36899;\&#24111;&#24195;&#30044;&#29987;&#22823;&#23398;\&#24111;&#30044;&#22823;%20&#23455;&#39443;\&#31278;&#23376;&#20241;&#30496;&#12289;&#31298;&#30330;&#33469;\&#12458;&#12458;&#12512;&#12462;QSD1\&#30330;&#29694;&#35299;&#26512;&#12289;RT-PCR\151130%20new%20&#30330;&#29694;&#35299;&#26512;&#12288;&#20462;&#27491;&#12487;&#12540;&#12479;&#12288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&#30740;&#31350;&#12289;&#22823;&#23398;&#38306;&#36899;\&#24111;&#24195;&#30044;&#29987;&#22823;&#23398;\&#24111;&#30044;&#22823;%20&#23455;&#39443;\&#31278;&#23376;&#20241;&#30496;&#12289;&#31298;&#30330;&#33469;\&#12458;&#12458;&#12512;&#12462;QSD1\&#30330;&#29694;&#35299;&#26512;&#12289;RT-PCR\151130%20new%20&#30330;&#29694;&#35299;&#26512;&#12288;&#20462;&#27491;&#12487;&#12540;&#12479;&#12288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&#30740;&#31350;&#12289;&#22823;&#23398;&#38306;&#36899;\&#24111;&#24195;&#30044;&#29987;&#22823;&#23398;\&#24111;&#30044;&#22823;%20&#23455;&#39443;\&#31278;&#23376;&#20241;&#30496;&#12289;&#31298;&#30330;&#33469;\&#12458;&#12458;&#12512;&#12462;QSD1\&#30330;&#29694;&#35299;&#26512;&#12289;RT-PCR\151130%20new%20&#30330;&#29694;&#35299;&#26512;&#12288;&#20462;&#27491;&#12487;&#12540;&#12479;&#12288;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ato\AppData\Local\Microsoft\Windows\Temporary%20Internet%20Files\Content.Outlook\9AT3QLTQ\&#30330;&#29694;&#37327;&#12414;&#12392;&#12417;&#65288;actin)&#9313;&#22577;&#21578;.xlsx" TargetMode="External"/><Relationship Id="rId1" Type="http://schemas.openxmlformats.org/officeDocument/2006/relationships/themeOverride" Target="../theme/themeOverride1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______1.xlsx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ato\AppData\Local\Microsoft\Windows\Temporary%20Internet%20Files\Content.Outlook\9AT3QLTQ\&#30330;&#29694;&#37327;&#12414;&#12392;&#12417;&#65288;actin)&#9313;&#22577;&#21578;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32177443247046622"/>
                  <c:y val="-0.12464527750884823"/>
                </c:manualLayout>
              </c:layout>
              <c:numFmt formatCode="#,##0.00000_ " sourceLinked="0"/>
            </c:trendlineLbl>
          </c:trendline>
          <c:xVal>
            <c:numRef>
              <c:f>'検量線 (151127 再解析)'!$D$6:$D$29</c:f>
              <c:numCache>
                <c:formatCode>General</c:formatCode>
                <c:ptCount val="24"/>
                <c:pt idx="0">
                  <c:v>10.153660351895418</c:v>
                </c:pt>
                <c:pt idx="1">
                  <c:v>10.153660351895418</c:v>
                </c:pt>
                <c:pt idx="2">
                  <c:v>10.153660351895418</c:v>
                </c:pt>
                <c:pt idx="3">
                  <c:v>9.153660351895418</c:v>
                </c:pt>
                <c:pt idx="4">
                  <c:v>9.153660351895418</c:v>
                </c:pt>
                <c:pt idx="5">
                  <c:v>9.153660351895418</c:v>
                </c:pt>
                <c:pt idx="6">
                  <c:v>8.153660351895418</c:v>
                </c:pt>
                <c:pt idx="7">
                  <c:v>8.153660351895418</c:v>
                </c:pt>
                <c:pt idx="8">
                  <c:v>8.153660351895418</c:v>
                </c:pt>
                <c:pt idx="9">
                  <c:v>7.153660351895418</c:v>
                </c:pt>
                <c:pt idx="10">
                  <c:v>7.153660351895418</c:v>
                </c:pt>
                <c:pt idx="11">
                  <c:v>7.153660351895418</c:v>
                </c:pt>
                <c:pt idx="12">
                  <c:v>6.153660351895418</c:v>
                </c:pt>
                <c:pt idx="13">
                  <c:v>6.153660351895418</c:v>
                </c:pt>
                <c:pt idx="14">
                  <c:v>6.153660351895418</c:v>
                </c:pt>
                <c:pt idx="15">
                  <c:v>5.153660351895418</c:v>
                </c:pt>
                <c:pt idx="16">
                  <c:v>5.153660351895418</c:v>
                </c:pt>
                <c:pt idx="17">
                  <c:v>5.153660351895418</c:v>
                </c:pt>
                <c:pt idx="18">
                  <c:v>4.1536603518954189</c:v>
                </c:pt>
                <c:pt idx="19">
                  <c:v>4.1536603518954189</c:v>
                </c:pt>
                <c:pt idx="20">
                  <c:v>4.1536603518954189</c:v>
                </c:pt>
                <c:pt idx="21">
                  <c:v>3.1536603518954185</c:v>
                </c:pt>
                <c:pt idx="22">
                  <c:v>3.1536603518954185</c:v>
                </c:pt>
                <c:pt idx="23">
                  <c:v>3.1536603518954185</c:v>
                </c:pt>
              </c:numCache>
            </c:numRef>
          </c:xVal>
          <c:yVal>
            <c:numRef>
              <c:f>'検量線 (151127 再解析)'!$E$6:$E$29</c:f>
              <c:numCache>
                <c:formatCode>General</c:formatCode>
                <c:ptCount val="24"/>
                <c:pt idx="6">
                  <c:v>7.14</c:v>
                </c:pt>
                <c:pt idx="7">
                  <c:v>7.1</c:v>
                </c:pt>
                <c:pt idx="9">
                  <c:v>10.66</c:v>
                </c:pt>
                <c:pt idx="10">
                  <c:v>10.62</c:v>
                </c:pt>
                <c:pt idx="12">
                  <c:v>14.08</c:v>
                </c:pt>
                <c:pt idx="13">
                  <c:v>14.03</c:v>
                </c:pt>
                <c:pt idx="15">
                  <c:v>17.28</c:v>
                </c:pt>
                <c:pt idx="16">
                  <c:v>17.239999999999998</c:v>
                </c:pt>
                <c:pt idx="18">
                  <c:v>20.61</c:v>
                </c:pt>
                <c:pt idx="19">
                  <c:v>20.57</c:v>
                </c:pt>
                <c:pt idx="21">
                  <c:v>23.91</c:v>
                </c:pt>
                <c:pt idx="22">
                  <c:v>23.8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5680128"/>
        <c:axId val="335681248"/>
      </c:scatterChart>
      <c:valAx>
        <c:axId val="335680128"/>
        <c:scaling>
          <c:orientation val="minMax"/>
          <c:max val="10"/>
        </c:scaling>
        <c:delete val="0"/>
        <c:axPos val="b"/>
        <c:numFmt formatCode="General" sourceLinked="1"/>
        <c:majorTickMark val="out"/>
        <c:minorTickMark val="none"/>
        <c:tickLblPos val="nextTo"/>
        <c:crossAx val="335681248"/>
        <c:crosses val="autoZero"/>
        <c:crossBetween val="midCat"/>
      </c:valAx>
      <c:valAx>
        <c:axId val="33568124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33568012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26540737897809336"/>
                  <c:y val="-0.13072235231553087"/>
                </c:manualLayout>
              </c:layout>
              <c:numFmt formatCode="#,##0.00000_ " sourceLinked="0"/>
            </c:trendlineLbl>
          </c:trendline>
          <c:xVal>
            <c:numRef>
              <c:f>'検量線 (151127 再解析)'!$J$6:$J$29</c:f>
              <c:numCache>
                <c:formatCode>General</c:formatCode>
                <c:ptCount val="24"/>
                <c:pt idx="0">
                  <c:v>9.4700477574182518</c:v>
                </c:pt>
                <c:pt idx="1">
                  <c:v>9.4700477574182518</c:v>
                </c:pt>
                <c:pt idx="2">
                  <c:v>9.4700477574182518</c:v>
                </c:pt>
                <c:pt idx="3">
                  <c:v>8.4700477574182518</c:v>
                </c:pt>
                <c:pt idx="4">
                  <c:v>8.4700477574182518</c:v>
                </c:pt>
                <c:pt idx="5">
                  <c:v>8.4700477574182518</c:v>
                </c:pt>
                <c:pt idx="6">
                  <c:v>7.4700477574182527</c:v>
                </c:pt>
                <c:pt idx="7">
                  <c:v>7.4700477574182527</c:v>
                </c:pt>
                <c:pt idx="8">
                  <c:v>7.4700477574182527</c:v>
                </c:pt>
                <c:pt idx="9">
                  <c:v>6.4700477574182527</c:v>
                </c:pt>
                <c:pt idx="10">
                  <c:v>6.4700477574182527</c:v>
                </c:pt>
                <c:pt idx="11">
                  <c:v>6.4700477574182527</c:v>
                </c:pt>
                <c:pt idx="12">
                  <c:v>5.4700477574182527</c:v>
                </c:pt>
                <c:pt idx="13">
                  <c:v>5.4700477574182527</c:v>
                </c:pt>
                <c:pt idx="14">
                  <c:v>5.4700477574182527</c:v>
                </c:pt>
                <c:pt idx="15">
                  <c:v>4.4700477574182527</c:v>
                </c:pt>
                <c:pt idx="16">
                  <c:v>4.4700477574182527</c:v>
                </c:pt>
                <c:pt idx="17">
                  <c:v>4.4700477574182527</c:v>
                </c:pt>
                <c:pt idx="18">
                  <c:v>3.4700477574182522</c:v>
                </c:pt>
                <c:pt idx="19">
                  <c:v>3.4700477574182522</c:v>
                </c:pt>
                <c:pt idx="20">
                  <c:v>3.4700477574182522</c:v>
                </c:pt>
                <c:pt idx="21">
                  <c:v>2.4700477574182522</c:v>
                </c:pt>
                <c:pt idx="22">
                  <c:v>2.4700477574182522</c:v>
                </c:pt>
                <c:pt idx="23">
                  <c:v>2.4700477574182522</c:v>
                </c:pt>
              </c:numCache>
            </c:numRef>
          </c:xVal>
          <c:yVal>
            <c:numRef>
              <c:f>'検量線 (151127 再解析)'!$K$6:$K$29</c:f>
              <c:numCache>
                <c:formatCode>General</c:formatCode>
                <c:ptCount val="24"/>
                <c:pt idx="3">
                  <c:v>6.45</c:v>
                </c:pt>
                <c:pt idx="4">
                  <c:v>6.49</c:v>
                </c:pt>
                <c:pt idx="5">
                  <c:v>6.5</c:v>
                </c:pt>
                <c:pt idx="6">
                  <c:v>10.09</c:v>
                </c:pt>
                <c:pt idx="7">
                  <c:v>10.130000000000001</c:v>
                </c:pt>
                <c:pt idx="8">
                  <c:v>10.130000000000001</c:v>
                </c:pt>
                <c:pt idx="9">
                  <c:v>13.6</c:v>
                </c:pt>
                <c:pt idx="10">
                  <c:v>13.65</c:v>
                </c:pt>
                <c:pt idx="11">
                  <c:v>13.65</c:v>
                </c:pt>
                <c:pt idx="12">
                  <c:v>17.079999999999998</c:v>
                </c:pt>
                <c:pt idx="13">
                  <c:v>17.11</c:v>
                </c:pt>
                <c:pt idx="14">
                  <c:v>17.12</c:v>
                </c:pt>
                <c:pt idx="15">
                  <c:v>20.61</c:v>
                </c:pt>
                <c:pt idx="16">
                  <c:v>20.62</c:v>
                </c:pt>
                <c:pt idx="17">
                  <c:v>20.63</c:v>
                </c:pt>
                <c:pt idx="18">
                  <c:v>23.96</c:v>
                </c:pt>
                <c:pt idx="19">
                  <c:v>24</c:v>
                </c:pt>
                <c:pt idx="20">
                  <c:v>24.02</c:v>
                </c:pt>
                <c:pt idx="21">
                  <c:v>27.34</c:v>
                </c:pt>
                <c:pt idx="22">
                  <c:v>27.43</c:v>
                </c:pt>
                <c:pt idx="23">
                  <c:v>27.5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5683488"/>
        <c:axId val="335979152"/>
      </c:scatterChart>
      <c:valAx>
        <c:axId val="3356834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35979152"/>
        <c:crosses val="autoZero"/>
        <c:crossBetween val="midCat"/>
      </c:valAx>
      <c:valAx>
        <c:axId val="33597915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33568348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28195200533274078"/>
                  <c:y val="-5.0393735054221553E-2"/>
                </c:manualLayout>
              </c:layout>
              <c:numFmt formatCode="#,##0.00000_ " sourceLinked="0"/>
            </c:trendlineLbl>
          </c:trendline>
          <c:xVal>
            <c:numRef>
              <c:f>'検量線 (151127 再解析)'!$P$6:$P$29</c:f>
              <c:numCache>
                <c:formatCode>General</c:formatCode>
                <c:ptCount val="24"/>
                <c:pt idx="0">
                  <c:v>9.4397532168669631</c:v>
                </c:pt>
                <c:pt idx="1">
                  <c:v>9.4397532168669631</c:v>
                </c:pt>
                <c:pt idx="2">
                  <c:v>9.4397532168669631</c:v>
                </c:pt>
                <c:pt idx="3">
                  <c:v>8.4397532168669631</c:v>
                </c:pt>
                <c:pt idx="4">
                  <c:v>8.4397532168669631</c:v>
                </c:pt>
                <c:pt idx="5">
                  <c:v>8.4397532168669631</c:v>
                </c:pt>
                <c:pt idx="6">
                  <c:v>7.4397532168669631</c:v>
                </c:pt>
                <c:pt idx="7">
                  <c:v>7.4397532168669631</c:v>
                </c:pt>
                <c:pt idx="8">
                  <c:v>7.4397532168669631</c:v>
                </c:pt>
                <c:pt idx="9">
                  <c:v>6.4397532168669631</c:v>
                </c:pt>
                <c:pt idx="10">
                  <c:v>6.4397532168669631</c:v>
                </c:pt>
                <c:pt idx="11">
                  <c:v>6.4397532168669631</c:v>
                </c:pt>
                <c:pt idx="12">
                  <c:v>5.4397532168669631</c:v>
                </c:pt>
                <c:pt idx="13">
                  <c:v>5.4397532168669631</c:v>
                </c:pt>
                <c:pt idx="14">
                  <c:v>5.4397532168669631</c:v>
                </c:pt>
                <c:pt idx="15">
                  <c:v>4.4397532168669631</c:v>
                </c:pt>
                <c:pt idx="16">
                  <c:v>4.4397532168669631</c:v>
                </c:pt>
                <c:pt idx="17">
                  <c:v>4.4397532168669631</c:v>
                </c:pt>
                <c:pt idx="18">
                  <c:v>3.4397532168669631</c:v>
                </c:pt>
                <c:pt idx="19">
                  <c:v>3.4397532168669631</c:v>
                </c:pt>
                <c:pt idx="20">
                  <c:v>3.4397532168669631</c:v>
                </c:pt>
                <c:pt idx="21">
                  <c:v>2.4397532168669631</c:v>
                </c:pt>
                <c:pt idx="22">
                  <c:v>2.4397532168669631</c:v>
                </c:pt>
                <c:pt idx="23">
                  <c:v>2.4397532168669631</c:v>
                </c:pt>
              </c:numCache>
            </c:numRef>
          </c:xVal>
          <c:yVal>
            <c:numRef>
              <c:f>'検量線 (151127 再解析)'!$Q$6:$Q$29</c:f>
              <c:numCache>
                <c:formatCode>General</c:formatCode>
                <c:ptCount val="24"/>
                <c:pt idx="3">
                  <c:v>8.23</c:v>
                </c:pt>
                <c:pt idx="4">
                  <c:v>8.1999999999999993</c:v>
                </c:pt>
                <c:pt idx="5">
                  <c:v>8.1999999999999993</c:v>
                </c:pt>
                <c:pt idx="6">
                  <c:v>11.77</c:v>
                </c:pt>
                <c:pt idx="7">
                  <c:v>11.74</c:v>
                </c:pt>
                <c:pt idx="8">
                  <c:v>11.74</c:v>
                </c:pt>
                <c:pt idx="9">
                  <c:v>15.06</c:v>
                </c:pt>
                <c:pt idx="10">
                  <c:v>15.03</c:v>
                </c:pt>
                <c:pt idx="11">
                  <c:v>15.03</c:v>
                </c:pt>
                <c:pt idx="12">
                  <c:v>18.54</c:v>
                </c:pt>
                <c:pt idx="13">
                  <c:v>18.5</c:v>
                </c:pt>
                <c:pt idx="14">
                  <c:v>18.510000000000002</c:v>
                </c:pt>
                <c:pt idx="15">
                  <c:v>21.88</c:v>
                </c:pt>
                <c:pt idx="16">
                  <c:v>21.88</c:v>
                </c:pt>
                <c:pt idx="17">
                  <c:v>21.86</c:v>
                </c:pt>
                <c:pt idx="18">
                  <c:v>25.24</c:v>
                </c:pt>
                <c:pt idx="19">
                  <c:v>25.33</c:v>
                </c:pt>
                <c:pt idx="20">
                  <c:v>25.31</c:v>
                </c:pt>
                <c:pt idx="21">
                  <c:v>28.52</c:v>
                </c:pt>
                <c:pt idx="22">
                  <c:v>28.55</c:v>
                </c:pt>
                <c:pt idx="23">
                  <c:v>28.5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5981392"/>
        <c:axId val="335981952"/>
      </c:scatterChart>
      <c:valAx>
        <c:axId val="3359813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35981952"/>
        <c:crosses val="autoZero"/>
        <c:crossBetween val="midCat"/>
      </c:valAx>
      <c:valAx>
        <c:axId val="33598195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33598139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4407426185960208E-2"/>
          <c:y val="5.6935998384817284E-2"/>
          <c:w val="0.82702898388529844"/>
          <c:h val="0.81459398344437717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1228093565635205"/>
                  <c:y val="9.9401978598828988E-2"/>
                </c:manualLayout>
              </c:layout>
              <c:numFmt formatCode="#,##0.00000_ " sourceLinked="0"/>
            </c:trendlineLbl>
          </c:trendline>
          <c:xVal>
            <c:numRef>
              <c:f>'検量線 (151127 再解析)'!$V$37:$V$51</c:f>
              <c:numCache>
                <c:formatCode>General</c:formatCode>
                <c:ptCount val="15"/>
                <c:pt idx="0">
                  <c:v>7.902667652729745</c:v>
                </c:pt>
                <c:pt idx="1">
                  <c:v>7.902667652729745</c:v>
                </c:pt>
                <c:pt idx="2">
                  <c:v>7.902667652729745</c:v>
                </c:pt>
                <c:pt idx="3">
                  <c:v>6.902667652729745</c:v>
                </c:pt>
                <c:pt idx="4">
                  <c:v>6.902667652729745</c:v>
                </c:pt>
                <c:pt idx="5">
                  <c:v>6.902667652729745</c:v>
                </c:pt>
                <c:pt idx="6">
                  <c:v>5.902667652729745</c:v>
                </c:pt>
                <c:pt idx="7">
                  <c:v>5.902667652729745</c:v>
                </c:pt>
                <c:pt idx="8">
                  <c:v>5.902667652729745</c:v>
                </c:pt>
                <c:pt idx="9">
                  <c:v>4.902667652729745</c:v>
                </c:pt>
                <c:pt idx="10">
                  <c:v>4.902667652729745</c:v>
                </c:pt>
                <c:pt idx="11">
                  <c:v>4.902667652729745</c:v>
                </c:pt>
                <c:pt idx="12">
                  <c:v>3.9026676527297455</c:v>
                </c:pt>
                <c:pt idx="13">
                  <c:v>3.9026676527297455</c:v>
                </c:pt>
                <c:pt idx="14">
                  <c:v>3.9026676527297455</c:v>
                </c:pt>
              </c:numCache>
            </c:numRef>
          </c:xVal>
          <c:yVal>
            <c:numRef>
              <c:f>'検量線 (151127 再解析)'!$W$37:$W$51</c:f>
              <c:numCache>
                <c:formatCode>General</c:formatCode>
                <c:ptCount val="15"/>
                <c:pt idx="0">
                  <c:v>11.02</c:v>
                </c:pt>
                <c:pt idx="1">
                  <c:v>11.03</c:v>
                </c:pt>
                <c:pt idx="2">
                  <c:v>11.03</c:v>
                </c:pt>
                <c:pt idx="3">
                  <c:v>14.57</c:v>
                </c:pt>
                <c:pt idx="4">
                  <c:v>14.58</c:v>
                </c:pt>
                <c:pt idx="5">
                  <c:v>14.59</c:v>
                </c:pt>
                <c:pt idx="6">
                  <c:v>17.98</c:v>
                </c:pt>
                <c:pt idx="7">
                  <c:v>17.989999999999998</c:v>
                </c:pt>
                <c:pt idx="8">
                  <c:v>18</c:v>
                </c:pt>
                <c:pt idx="9">
                  <c:v>21.75</c:v>
                </c:pt>
                <c:pt idx="10">
                  <c:v>21.75</c:v>
                </c:pt>
                <c:pt idx="11">
                  <c:v>21.76</c:v>
                </c:pt>
                <c:pt idx="12">
                  <c:v>25.16</c:v>
                </c:pt>
                <c:pt idx="13">
                  <c:v>25.15</c:v>
                </c:pt>
                <c:pt idx="14">
                  <c:v>25.1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5984192"/>
        <c:axId val="335984752"/>
      </c:scatterChart>
      <c:valAx>
        <c:axId val="335984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35984752"/>
        <c:crosses val="autoZero"/>
        <c:crossBetween val="midCat"/>
        <c:majorUnit val="2"/>
      </c:valAx>
      <c:valAx>
        <c:axId val="33598475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33598419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455402435239158"/>
          <c:y val="6.4814835388660522E-2"/>
          <c:w val="0.81933552055992998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:\Users\yamane\Desktop\休眠データ\コムギ\T.mono boe. RIL56\[komugi380-actin②data.xls]報告'!$K$4</c:f>
              <c:strCache>
                <c:ptCount val="1"/>
                <c:pt idx="0">
                  <c:v>TaQsd1/TaActin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:\Users\yamane\Desktop\休眠データ\コムギ\T.mono boe. RIL56\[komugi380-actin②data.xls]報告'!$L$5:$L$7</c:f>
                <c:numCache>
                  <c:formatCode>General</c:formatCode>
                  <c:ptCount val="3"/>
                  <c:pt idx="0">
                    <c:v>8.1481238827853159E-2</c:v>
                  </c:pt>
                  <c:pt idx="1">
                    <c:v>0.28725199071136959</c:v>
                  </c:pt>
                  <c:pt idx="2">
                    <c:v>0.10830567642775323</c:v>
                  </c:pt>
                </c:numCache>
              </c:numRef>
            </c:plus>
            <c:minus>
              <c:numRef>
                <c:f>'C:\Users\yamane\Desktop\休眠データ\コムギ\T.mono boe. RIL56\[komugi380-actin②data.xls]報告'!$L$5:$L$7</c:f>
                <c:numCache>
                  <c:formatCode>General</c:formatCode>
                  <c:ptCount val="3"/>
                  <c:pt idx="0">
                    <c:v>8.1481238827853159E-2</c:v>
                  </c:pt>
                  <c:pt idx="1">
                    <c:v>0.28725199071136959</c:v>
                  </c:pt>
                  <c:pt idx="2">
                    <c:v>0.108305676427753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:\Users\yamane\Desktop\休眠データ\コムギ\T.mono boe. RIL56\[komugi380-actin②data.xls]報告'!$J$5:$J$7</c:f>
              <c:strCache>
                <c:ptCount val="3"/>
                <c:pt idx="0">
                  <c:v>T. monococum</c:v>
                </c:pt>
                <c:pt idx="1">
                  <c:v>T. boeoticum</c:v>
                </c:pt>
                <c:pt idx="2">
                  <c:v>RIL56</c:v>
                </c:pt>
              </c:strCache>
            </c:strRef>
          </c:cat>
          <c:val>
            <c:numRef>
              <c:f>'C:\Users\yamane\Desktop\休眠データ\コムギ\T.mono boe. RIL56\[komugi380-actin②data.xls]報告'!$K$5:$K$7</c:f>
              <c:numCache>
                <c:formatCode>General</c:formatCode>
                <c:ptCount val="3"/>
                <c:pt idx="0">
                  <c:v>1.1254643489047131</c:v>
                </c:pt>
                <c:pt idx="1">
                  <c:v>1.2320848603630488</c:v>
                </c:pt>
                <c:pt idx="2">
                  <c:v>1.27392125518482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6140016"/>
        <c:axId val="336140576"/>
      </c:barChart>
      <c:catAx>
        <c:axId val="336140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36140576"/>
        <c:crosses val="autoZero"/>
        <c:auto val="1"/>
        <c:lblAlgn val="ctr"/>
        <c:lblOffset val="100"/>
        <c:noMultiLvlLbl val="0"/>
      </c:catAx>
      <c:valAx>
        <c:axId val="3361405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600" i="1" dirty="0" smtClean="0"/>
                  <a:t>Qsd1/Actin</a:t>
                </a:r>
                <a:endParaRPr lang="ja-JP" altLang="en-US" sz="1600" i="1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solidFill>
            <a:sysClr val="window" lastClr="FFFFFF"/>
          </a:solidFill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361400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i="1" dirty="0" smtClean="0"/>
              <a:t>Qsd1</a:t>
            </a:r>
            <a:r>
              <a:rPr lang="ja-JP" altLang="en-US" i="1" dirty="0"/>
              <a:t>　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 w="9525">
                <a:noFill/>
                <a:miter lim="800000"/>
              </a:ln>
              <a:effectLst/>
            </c:spPr>
          </c:marker>
          <c:xVal>
            <c:numRef>
              <c:f>'380'!$J$5:$J$13</c:f>
              <c:numCache>
                <c:formatCode>0.00_ </c:formatCode>
                <c:ptCount val="9"/>
                <c:pt idx="0">
                  <c:v>9.4202858849419169</c:v>
                </c:pt>
                <c:pt idx="1">
                  <c:v>8.7213158806058981</c:v>
                </c:pt>
                <c:pt idx="2">
                  <c:v>8.0223458762698794</c:v>
                </c:pt>
                <c:pt idx="3">
                  <c:v>7.3233758719338606</c:v>
                </c:pt>
                <c:pt idx="4">
                  <c:v>6.6244058675978419</c:v>
                </c:pt>
                <c:pt idx="5">
                  <c:v>5.9254358632618231</c:v>
                </c:pt>
                <c:pt idx="6">
                  <c:v>5.2264658589258044</c:v>
                </c:pt>
                <c:pt idx="7">
                  <c:v>4.5274958545897865</c:v>
                </c:pt>
                <c:pt idx="8">
                  <c:v>3.8285258502537669</c:v>
                </c:pt>
              </c:numCache>
            </c:numRef>
          </c:xVal>
          <c:yVal>
            <c:numRef>
              <c:f>'380'!$K$5:$K$13</c:f>
              <c:numCache>
                <c:formatCode>0.00_ </c:formatCode>
                <c:ptCount val="9"/>
                <c:pt idx="0">
                  <c:v>5.140559196472168</c:v>
                </c:pt>
                <c:pt idx="1">
                  <c:v>7.4035415649414062</c:v>
                </c:pt>
                <c:pt idx="2">
                  <c:v>8.9256868362426758</c:v>
                </c:pt>
                <c:pt idx="3">
                  <c:v>12.613036155700684</c:v>
                </c:pt>
                <c:pt idx="4">
                  <c:v>14.400337219238281</c:v>
                </c:pt>
                <c:pt idx="5">
                  <c:v>16.942178726196289</c:v>
                </c:pt>
                <c:pt idx="6">
                  <c:v>19.089054107666016</c:v>
                </c:pt>
                <c:pt idx="7">
                  <c:v>21.649099349975586</c:v>
                </c:pt>
                <c:pt idx="8">
                  <c:v>23.7535457611083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6142256"/>
        <c:axId val="336142816"/>
      </c:scatterChart>
      <c:valAx>
        <c:axId val="336142256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baseline="0"/>
                  <a:t>Log copy number</a:t>
                </a:r>
                <a:endParaRPr lang="ja-JP" altLang="en-US" sz="1200" baseline="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_ 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333333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defRPr>
            </a:pPr>
            <a:endParaRPr lang="ja-JP"/>
          </a:p>
        </c:txPr>
        <c:crossAx val="336142816"/>
        <c:crosses val="autoZero"/>
        <c:crossBetween val="midCat"/>
      </c:valAx>
      <c:valAx>
        <c:axId val="3361428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Ct</a:t>
                </a:r>
                <a:endParaRPr lang="ja-JP" altLang="en-US" sz="120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_ 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36142256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i="1"/>
              <a:t>Actin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C:\Users\yamane\Desktop\休眠データ\コムギ\T.mono boe. RIL56\[komugi_380-actin_data.xls]actin'!$K$29</c:f>
              <c:strCache>
                <c:ptCount val="1"/>
                <c:pt idx="0">
                  <c:v>Cт Mean</c:v>
                </c:pt>
              </c:strCache>
            </c:strRef>
          </c:tx>
          <c:spPr>
            <a:ln w="19050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9525" cap="sq">
                <a:solidFill>
                  <a:sysClr val="windowText" lastClr="000000"/>
                </a:solidFill>
                <a:miter lim="800000"/>
              </a:ln>
              <a:effectLst/>
            </c:spPr>
          </c:marker>
          <c:trendline>
            <c:spPr>
              <a:ln w="9525"/>
            </c:spPr>
            <c:trendlineType val="linear"/>
            <c:dispRSqr val="0"/>
            <c:dispEq val="0"/>
          </c:trendline>
          <c:xVal>
            <c:numRef>
              <c:f>'C:\Users\yamane\Desktop\休眠データ\コムギ\T.mono boe. RIL56\[komugi_380-actin_data.xls]actin'!$J$30:$J$38</c:f>
              <c:numCache>
                <c:formatCode>General</c:formatCode>
                <c:ptCount val="9"/>
                <c:pt idx="0">
                  <c:v>8.4941545940184415</c:v>
                </c:pt>
                <c:pt idx="1">
                  <c:v>7.7951845896824228</c:v>
                </c:pt>
                <c:pt idx="2">
                  <c:v>7.0962145853464049</c:v>
                </c:pt>
                <c:pt idx="3">
                  <c:v>6.3972445810103853</c:v>
                </c:pt>
                <c:pt idx="4">
                  <c:v>5.6982745766743674</c:v>
                </c:pt>
                <c:pt idx="5">
                  <c:v>4.9993045723383487</c:v>
                </c:pt>
                <c:pt idx="6">
                  <c:v>4.300334568002329</c:v>
                </c:pt>
                <c:pt idx="7">
                  <c:v>3.6013645636663112</c:v>
                </c:pt>
                <c:pt idx="8">
                  <c:v>2.9023945593302924</c:v>
                </c:pt>
              </c:numCache>
            </c:numRef>
          </c:xVal>
          <c:yVal>
            <c:numRef>
              <c:f>'C:\Users\yamane\Desktop\休眠データ\コムギ\T.mono boe. RIL56\[komugi_380-actin_data.xls]actin'!$K$30:$K$38</c:f>
              <c:numCache>
                <c:formatCode>General</c:formatCode>
                <c:ptCount val="9"/>
                <c:pt idx="0">
                  <c:v>7.561119556427002</c:v>
                </c:pt>
                <c:pt idx="1">
                  <c:v>9.8018827438354492</c:v>
                </c:pt>
                <c:pt idx="2">
                  <c:v>12.101287841796875</c:v>
                </c:pt>
                <c:pt idx="3">
                  <c:v>14.638453483581543</c:v>
                </c:pt>
                <c:pt idx="4">
                  <c:v>17.021137237548828</c:v>
                </c:pt>
                <c:pt idx="5">
                  <c:v>19.333526611328125</c:v>
                </c:pt>
                <c:pt idx="6">
                  <c:v>21.845552444458008</c:v>
                </c:pt>
                <c:pt idx="7">
                  <c:v>24.00248908996582</c:v>
                </c:pt>
                <c:pt idx="8">
                  <c:v>26.23410797119140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6145056"/>
        <c:axId val="336145616"/>
      </c:scatterChart>
      <c:valAx>
        <c:axId val="336145056"/>
        <c:scaling>
          <c:orientation val="minMax"/>
          <c:max val="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100"/>
                  <a:t>Log copy number</a:t>
                </a:r>
                <a:endParaRPr lang="ja-JP" altLang="en-US" sz="110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ysClr val="windowText" lastClr="000000"/>
            </a:solidFill>
            <a:round/>
          </a:ln>
          <a:effectLst/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333333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defRPr>
            </a:pPr>
            <a:endParaRPr lang="ja-JP"/>
          </a:p>
        </c:txPr>
        <c:crossAx val="336145616"/>
        <c:crosses val="autoZero"/>
        <c:crossBetween val="midCat"/>
      </c:valAx>
      <c:valAx>
        <c:axId val="336145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t</a:t>
                </a:r>
                <a:endParaRPr lang="ja-JP" altLang="en-US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36145056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5004</cdr:x>
      <cdr:y>0.53757</cdr:y>
    </cdr:from>
    <cdr:to>
      <cdr:x>0.72088</cdr:x>
      <cdr:y>0.7493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330325" y="1466340"/>
          <a:ext cx="1409368" cy="5775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900" dirty="0"/>
            <a:t>y =</a:t>
          </a:r>
          <a:r>
            <a:rPr lang="en-US" altLang="ja-JP" sz="900" baseline="0" dirty="0"/>
            <a:t> -3.38223x + 36.84047</a:t>
          </a:r>
        </a:p>
        <a:p xmlns:a="http://schemas.openxmlformats.org/drawingml/2006/main">
          <a:r>
            <a:rPr lang="en-US" altLang="ja-JP" sz="900" dirty="0"/>
            <a:t>R²=0.997042</a:t>
          </a:r>
          <a:endParaRPr lang="ja-JP" altLang="en-US" sz="900" dirty="0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18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4" y="2"/>
            <a:ext cx="2944124" cy="4953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59" tIns="46028" rIns="92059" bIns="46028" numCol="1" anchor="t" anchorCtr="0" compatLnSpc="1">
            <a:prstTxWarp prst="textNoShape">
              <a:avLst/>
            </a:prstTxWarp>
          </a:bodyPr>
          <a:lstStyle>
            <a:lvl1pPr defTabSz="920561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3187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0381" y="2"/>
            <a:ext cx="2944124" cy="4953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59" tIns="46028" rIns="92059" bIns="46028" numCol="1" anchor="t" anchorCtr="0" compatLnSpc="1">
            <a:prstTxWarp prst="textNoShape">
              <a:avLst/>
            </a:prstTxWarp>
          </a:bodyPr>
          <a:lstStyle>
            <a:lvl1pPr algn="r" defTabSz="920561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3188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4" y="9429676"/>
            <a:ext cx="2944124" cy="4969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59" tIns="46028" rIns="92059" bIns="46028" numCol="1" anchor="b" anchorCtr="0" compatLnSpc="1">
            <a:prstTxWarp prst="textNoShape">
              <a:avLst/>
            </a:prstTxWarp>
          </a:bodyPr>
          <a:lstStyle>
            <a:lvl1pPr defTabSz="920561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3189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0381" y="9429676"/>
            <a:ext cx="2944124" cy="4969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59" tIns="46028" rIns="92059" bIns="46028" numCol="1" anchor="b" anchorCtr="0" compatLnSpc="1">
            <a:prstTxWarp prst="textNoShape">
              <a:avLst/>
            </a:prstTxWarp>
          </a:bodyPr>
          <a:lstStyle>
            <a:lvl1pPr algn="r" defTabSz="920561" eaLnBrk="1" hangingPunct="1">
              <a:defRPr sz="1200"/>
            </a:lvl1pPr>
          </a:lstStyle>
          <a:p>
            <a:pPr>
              <a:defRPr/>
            </a:pPr>
            <a:fld id="{BB673EC1-8B24-484C-AB9B-FCF84CB797C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5370727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4" y="2"/>
            <a:ext cx="2944124" cy="4953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59" tIns="46028" rIns="92059" bIns="46028" numCol="1" anchor="t" anchorCtr="0" compatLnSpc="1">
            <a:prstTxWarp prst="textNoShape">
              <a:avLst/>
            </a:prstTxWarp>
          </a:bodyPr>
          <a:lstStyle>
            <a:lvl1pPr defTabSz="920561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381" y="2"/>
            <a:ext cx="2944124" cy="4953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59" tIns="46028" rIns="92059" bIns="46028" numCol="1" anchor="t" anchorCtr="0" compatLnSpc="1">
            <a:prstTxWarp prst="textNoShape">
              <a:avLst/>
            </a:prstTxWarp>
          </a:bodyPr>
          <a:lstStyle>
            <a:lvl1pPr algn="r" defTabSz="920561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20750" y="746125"/>
            <a:ext cx="4959350" cy="371951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922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300" y="4715632"/>
            <a:ext cx="5437506" cy="44663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59" tIns="46028" rIns="92059" bIns="4602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922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4" y="9429676"/>
            <a:ext cx="2944124" cy="4969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59" tIns="46028" rIns="92059" bIns="46028" numCol="1" anchor="b" anchorCtr="0" compatLnSpc="1">
            <a:prstTxWarp prst="textNoShape">
              <a:avLst/>
            </a:prstTxWarp>
          </a:bodyPr>
          <a:lstStyle>
            <a:lvl1pPr defTabSz="920561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22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381" y="9429676"/>
            <a:ext cx="2944124" cy="4969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59" tIns="46028" rIns="92059" bIns="46028" numCol="1" anchor="b" anchorCtr="0" compatLnSpc="1">
            <a:prstTxWarp prst="textNoShape">
              <a:avLst/>
            </a:prstTxWarp>
          </a:bodyPr>
          <a:lstStyle>
            <a:lvl1pPr algn="r" defTabSz="920561" eaLnBrk="1" hangingPunct="1">
              <a:defRPr sz="1200"/>
            </a:lvl1pPr>
          </a:lstStyle>
          <a:p>
            <a:pPr>
              <a:defRPr/>
            </a:pPr>
            <a:fld id="{FC42FD3E-EF51-4C20-A1FF-AAB6323618C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6403553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C5538C3-5773-4158-93CA-454D48660467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061369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6801C11-71CB-4080-BAE4-CCD5C0FA8BFD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871915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DAC3E52-5D53-440E-B683-B20169035C6D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132298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BDC6B1F-31CD-46F9-81EF-4D456434B71D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11455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A97A7FB-B44D-407E-9CB8-9A0F923048D1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859458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1DFDDC1-168C-4261-8A7A-D763F2E19851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946552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1E698C6-5D71-4775-9058-4C44B73184EE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200185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71D4716-5565-4225-A1E4-65807412A789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61218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965A3D3-F279-4447-A508-232CE1BDE9EF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246076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31F7764-FAB3-442C-9DD5-39EA40ED5D59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599880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FF4C92A-8A46-453F-B101-0AC464A8CB09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514336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DC8C6D55-C34E-49E3-A608-9B27B99A29E6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810487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</p:sldLayoutIdLst>
  <p:hf hdr="0" ftr="0" dt="0"/>
  <p:txStyles>
    <p:titleStyle>
      <a:lvl1pPr algn="ctr" defTabSz="914378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2" indent="-342892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1" indent="-285743" algn="l" defTabSz="914378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2.emf"/><Relationship Id="rId4" Type="http://schemas.openxmlformats.org/officeDocument/2006/relationships/package" Target="../embeddings/Microsoft_Excel_______2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965A3D3-F279-4447-A508-232CE1BDE9EF}" type="slidenum">
              <a:rPr lang="en-US" altLang="ja-JP" smtClean="0"/>
              <a:pPr>
                <a:defRPr/>
              </a:pPr>
              <a:t>1</a:t>
            </a:fld>
            <a:endParaRPr lang="en-US" altLang="ja-JP" dirty="0"/>
          </a:p>
        </p:txBody>
      </p:sp>
      <p:grpSp>
        <p:nvGrpSpPr>
          <p:cNvPr id="4" name="グループ化 3"/>
          <p:cNvGrpSpPr/>
          <p:nvPr/>
        </p:nvGrpSpPr>
        <p:grpSpPr>
          <a:xfrm>
            <a:off x="1426597" y="2913171"/>
            <a:ext cx="4019963" cy="2548580"/>
            <a:chOff x="3599303" y="3507498"/>
            <a:chExt cx="5149161" cy="3264469"/>
          </a:xfrm>
        </p:grpSpPr>
        <p:pic>
          <p:nvPicPr>
            <p:cNvPr id="5" name="Picture 2" descr="C:\Users\Kazumitsu Onishi\AppData\Local\Microsoft\Windows\Temporary Internet Files\Content.Outlook\C01SPN1F\ATTO9886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3" t="20851" r="44921" b="16502"/>
            <a:stretch/>
          </p:blipFill>
          <p:spPr bwMode="auto">
            <a:xfrm>
              <a:off x="4932040" y="3891502"/>
              <a:ext cx="2930668" cy="28642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" name="グループ化 5"/>
            <p:cNvGrpSpPr/>
            <p:nvPr/>
          </p:nvGrpSpPr>
          <p:grpSpPr>
            <a:xfrm>
              <a:off x="4899159" y="3507498"/>
              <a:ext cx="3161510" cy="403780"/>
              <a:chOff x="1764978" y="3363621"/>
              <a:chExt cx="3804371" cy="403780"/>
            </a:xfrm>
          </p:grpSpPr>
          <p:sp>
            <p:nvSpPr>
              <p:cNvPr id="22" name="テキスト ボックス 21"/>
              <p:cNvSpPr txBox="1"/>
              <p:nvPr/>
            </p:nvSpPr>
            <p:spPr>
              <a:xfrm>
                <a:off x="1764978" y="3372043"/>
                <a:ext cx="732717" cy="394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 smtClean="0">
                    <a:cs typeface="Arial" panose="020B0604020202020204" pitchFamily="34" charset="0"/>
                  </a:rPr>
                  <a:t>CS</a:t>
                </a:r>
                <a:endParaRPr kumimoji="1" lang="ja-JP" altLang="en-US" sz="14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>
                <a:off x="2293039" y="3372043"/>
                <a:ext cx="391578" cy="394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cs typeface="Arial" panose="020B0604020202020204" pitchFamily="34" charset="0"/>
                  </a:rPr>
                  <a:t>1</a:t>
                </a:r>
                <a:endParaRPr kumimoji="1" lang="ja-JP" altLang="en-US" sz="14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>
                <a:off x="2664186" y="3363622"/>
                <a:ext cx="391578" cy="394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 smtClean="0">
                    <a:cs typeface="Arial" panose="020B0604020202020204" pitchFamily="34" charset="0"/>
                  </a:rPr>
                  <a:t>2</a:t>
                </a:r>
                <a:endParaRPr kumimoji="1" lang="ja-JP" altLang="en-US" sz="14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>
                <a:off x="3051526" y="3363621"/>
                <a:ext cx="391578" cy="394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>
                    <a:cs typeface="Arial" panose="020B0604020202020204" pitchFamily="34" charset="0"/>
                  </a:rPr>
                  <a:t>3</a:t>
                </a:r>
                <a:endParaRPr kumimoji="1" lang="ja-JP" altLang="en-US" sz="14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3391182" y="3373170"/>
                <a:ext cx="391578" cy="394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 smtClean="0">
                    <a:cs typeface="Arial" panose="020B0604020202020204" pitchFamily="34" charset="0"/>
                  </a:rPr>
                  <a:t>4</a:t>
                </a:r>
                <a:endParaRPr kumimoji="1" lang="ja-JP" altLang="en-US" sz="14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>
                <a:off x="3758091" y="3372044"/>
                <a:ext cx="391578" cy="394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 smtClean="0">
                    <a:cs typeface="Arial" panose="020B0604020202020204" pitchFamily="34" charset="0"/>
                  </a:rPr>
                  <a:t>5</a:t>
                </a:r>
                <a:endParaRPr kumimoji="1" lang="ja-JP" altLang="en-US" sz="14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4122472" y="3364748"/>
                <a:ext cx="391578" cy="394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 smtClean="0">
                    <a:cs typeface="Arial" panose="020B0604020202020204" pitchFamily="34" charset="0"/>
                  </a:rPr>
                  <a:t>6</a:t>
                </a:r>
                <a:endParaRPr kumimoji="1" lang="ja-JP" altLang="en-US" sz="14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4386541" y="3363624"/>
                <a:ext cx="1182808" cy="394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 smtClean="0">
                    <a:cs typeface="Arial" panose="020B0604020202020204" pitchFamily="34" charset="0"/>
                  </a:rPr>
                  <a:t>CS  M</a:t>
                </a:r>
                <a:endParaRPr kumimoji="1" lang="ja-JP" altLang="en-US" sz="1400" dirty="0"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7" name="直線矢印コネクタ 6"/>
            <p:cNvCxnSpPr/>
            <p:nvPr/>
          </p:nvCxnSpPr>
          <p:spPr>
            <a:xfrm flipH="1">
              <a:off x="7884368" y="5661248"/>
              <a:ext cx="23908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矢印コネクタ 7"/>
            <p:cNvCxnSpPr/>
            <p:nvPr/>
          </p:nvCxnSpPr>
          <p:spPr>
            <a:xfrm flipH="1">
              <a:off x="7873735" y="5355436"/>
              <a:ext cx="23908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テキスト ボックス 8"/>
            <p:cNvSpPr txBox="1"/>
            <p:nvPr/>
          </p:nvSpPr>
          <p:spPr>
            <a:xfrm>
              <a:off x="8060669" y="4908418"/>
              <a:ext cx="564299" cy="354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>
                  <a:ea typeface="Gulim" panose="020B0600000101010101" pitchFamily="34" charset="-127"/>
                  <a:cs typeface="Arial" panose="020B0604020202020204" pitchFamily="34" charset="0"/>
                </a:rPr>
                <a:t>400 </a:t>
              </a:r>
              <a:endParaRPr kumimoji="1" lang="ja-JP" altLang="en-US" sz="1200" dirty="0">
                <a:ea typeface="Gulim" panose="020B0600000101010101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8081936" y="5478705"/>
              <a:ext cx="666528" cy="354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>
                  <a:ea typeface="Gulim" panose="020B0600000101010101" pitchFamily="34" charset="-127"/>
                  <a:cs typeface="Arial" panose="020B0604020202020204" pitchFamily="34" charset="0"/>
                </a:rPr>
                <a:t>200 </a:t>
              </a:r>
              <a:endParaRPr kumimoji="1" lang="ja-JP" altLang="en-US" sz="1200" dirty="0">
                <a:ea typeface="Gulim" panose="020B0600000101010101" pitchFamily="34" charset="-127"/>
                <a:cs typeface="Arial" panose="020B0604020202020204" pitchFamily="34" charset="0"/>
              </a:endParaRPr>
            </a:p>
          </p:txBody>
        </p:sp>
        <p:cxnSp>
          <p:nvCxnSpPr>
            <p:cNvPr id="11" name="直線矢印コネクタ 10"/>
            <p:cNvCxnSpPr/>
            <p:nvPr/>
          </p:nvCxnSpPr>
          <p:spPr>
            <a:xfrm flipH="1">
              <a:off x="7873735" y="5106450"/>
              <a:ext cx="23908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矢印コネクタ 11"/>
            <p:cNvCxnSpPr/>
            <p:nvPr/>
          </p:nvCxnSpPr>
          <p:spPr>
            <a:xfrm flipH="1">
              <a:off x="7884368" y="6258578"/>
              <a:ext cx="23908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/>
            <p:cNvSpPr txBox="1"/>
            <p:nvPr/>
          </p:nvSpPr>
          <p:spPr>
            <a:xfrm>
              <a:off x="8074840" y="5189091"/>
              <a:ext cx="635770" cy="354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>
                  <a:ea typeface="Gulim" panose="020B0600000101010101" pitchFamily="34" charset="-127"/>
                  <a:cs typeface="Arial" panose="020B0604020202020204" pitchFamily="34" charset="0"/>
                </a:rPr>
                <a:t>300</a:t>
              </a:r>
              <a:endParaRPr kumimoji="1" lang="ja-JP" altLang="en-US" sz="1200" dirty="0">
                <a:ea typeface="Gulim" panose="020B0600000101010101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8083691" y="6089300"/>
              <a:ext cx="664773" cy="354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>
                  <a:ea typeface="Gulim" panose="020B0600000101010101" pitchFamily="34" charset="-127"/>
                  <a:cs typeface="Arial" panose="020B0604020202020204" pitchFamily="34" charset="0"/>
                </a:rPr>
                <a:t>100 </a:t>
              </a:r>
              <a:endParaRPr kumimoji="1" lang="ja-JP" altLang="en-US" sz="1200" dirty="0">
                <a:ea typeface="Gulim" panose="020B0600000101010101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8083690" y="6417160"/>
              <a:ext cx="626921" cy="354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>
                  <a:ea typeface="Gulim" panose="020B0600000101010101" pitchFamily="34" charset="-127"/>
                  <a:cs typeface="Arial" panose="020B0604020202020204" pitchFamily="34" charset="0"/>
                </a:rPr>
                <a:t>(</a:t>
              </a:r>
              <a:r>
                <a:rPr lang="en-US" altLang="ja-JP" sz="1200" dirty="0" err="1" smtClean="0">
                  <a:ea typeface="Gulim" panose="020B0600000101010101" pitchFamily="34" charset="-127"/>
                  <a:cs typeface="Arial" panose="020B0604020202020204" pitchFamily="34" charset="0"/>
                </a:rPr>
                <a:t>bp</a:t>
              </a:r>
              <a:r>
                <a:rPr lang="en-US" altLang="ja-JP" sz="1200" dirty="0" smtClean="0">
                  <a:ea typeface="Gulim" panose="020B0600000101010101" pitchFamily="34" charset="-127"/>
                  <a:cs typeface="Arial" panose="020B0604020202020204" pitchFamily="34" charset="0"/>
                </a:rPr>
                <a:t>) </a:t>
              </a:r>
              <a:endParaRPr kumimoji="1" lang="ja-JP" altLang="en-US" sz="1200" dirty="0">
                <a:ea typeface="Gulim" panose="020B0600000101010101" pitchFamily="34" charset="-127"/>
                <a:cs typeface="Arial" panose="020B0604020202020204" pitchFamily="34" charset="0"/>
              </a:endParaRPr>
            </a:p>
          </p:txBody>
        </p:sp>
        <p:cxnSp>
          <p:nvCxnSpPr>
            <p:cNvPr id="16" name="直線矢印コネクタ 15"/>
            <p:cNvCxnSpPr/>
            <p:nvPr/>
          </p:nvCxnSpPr>
          <p:spPr>
            <a:xfrm>
              <a:off x="4525600" y="5266492"/>
              <a:ext cx="406440" cy="0"/>
            </a:xfrm>
            <a:prstGeom prst="straightConnector1">
              <a:avLst/>
            </a:prstGeom>
            <a:ln w="34925">
              <a:solidFill>
                <a:srgbClr val="FF00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/>
            <p:cNvSpPr txBox="1"/>
            <p:nvPr/>
          </p:nvSpPr>
          <p:spPr>
            <a:xfrm flipH="1">
              <a:off x="3896487" y="5033828"/>
              <a:ext cx="674265" cy="47307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b="1" dirty="0" smtClean="0">
                  <a:solidFill>
                    <a:srgbClr val="C00000"/>
                  </a:solidFill>
                  <a:ea typeface="Gulim" panose="020B0600000101010101" pitchFamily="34" charset="-127"/>
                  <a:cs typeface="Arial" panose="020B0604020202020204" pitchFamily="34" charset="0"/>
                </a:rPr>
                <a:t>5A</a:t>
              </a:r>
              <a:endParaRPr kumimoji="1" lang="ja-JP" altLang="en-US" b="1" dirty="0">
                <a:solidFill>
                  <a:srgbClr val="C00000"/>
                </a:solidFill>
                <a:ea typeface="Gulim" panose="020B0600000101010101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 flipH="1">
              <a:off x="3599303" y="5508883"/>
              <a:ext cx="971448" cy="4730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b="1" dirty="0" smtClean="0">
                  <a:solidFill>
                    <a:srgbClr val="C00000"/>
                  </a:solidFill>
                  <a:ea typeface="Gulim" panose="020B0600000101010101" pitchFamily="34" charset="-127"/>
                  <a:cs typeface="Arial" panose="020B0604020202020204" pitchFamily="34" charset="0"/>
                </a:rPr>
                <a:t>5B</a:t>
              </a:r>
              <a:endParaRPr kumimoji="1" lang="ja-JP" altLang="en-US" b="1" dirty="0">
                <a:solidFill>
                  <a:srgbClr val="C00000"/>
                </a:solidFill>
                <a:ea typeface="Gulim" panose="020B0600000101010101" pitchFamily="34" charset="-127"/>
                <a:cs typeface="Arial" panose="020B0604020202020204" pitchFamily="34" charset="0"/>
              </a:endParaRPr>
            </a:p>
          </p:txBody>
        </p:sp>
        <p:cxnSp>
          <p:nvCxnSpPr>
            <p:cNvPr id="19" name="直線矢印コネクタ 18"/>
            <p:cNvCxnSpPr/>
            <p:nvPr/>
          </p:nvCxnSpPr>
          <p:spPr>
            <a:xfrm>
              <a:off x="4525600" y="5817260"/>
              <a:ext cx="406440" cy="0"/>
            </a:xfrm>
            <a:prstGeom prst="straightConnector1">
              <a:avLst/>
            </a:prstGeom>
            <a:ln w="34925">
              <a:solidFill>
                <a:srgbClr val="FF00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矢印コネクタ 19"/>
            <p:cNvCxnSpPr/>
            <p:nvPr/>
          </p:nvCxnSpPr>
          <p:spPr>
            <a:xfrm>
              <a:off x="4525600" y="5917383"/>
              <a:ext cx="406440" cy="0"/>
            </a:xfrm>
            <a:prstGeom prst="straightConnector1">
              <a:avLst/>
            </a:prstGeom>
            <a:ln w="34925">
              <a:solidFill>
                <a:srgbClr val="FF00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テキスト ボックス 20"/>
            <p:cNvSpPr txBox="1"/>
            <p:nvPr/>
          </p:nvSpPr>
          <p:spPr>
            <a:xfrm flipH="1">
              <a:off x="3615408" y="5768521"/>
              <a:ext cx="971448" cy="4730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b="1" dirty="0">
                  <a:solidFill>
                    <a:srgbClr val="C00000"/>
                  </a:solidFill>
                  <a:ea typeface="Gulim" panose="020B0600000101010101" pitchFamily="34" charset="-127"/>
                  <a:cs typeface="Arial" panose="020B0604020202020204" pitchFamily="34" charset="0"/>
                </a:rPr>
                <a:t>5D </a:t>
              </a:r>
              <a:endParaRPr kumimoji="1" lang="ja-JP" altLang="en-US" b="1" dirty="0">
                <a:solidFill>
                  <a:srgbClr val="C00000"/>
                </a:solidFill>
                <a:ea typeface="Gulim" panose="020B0600000101010101" pitchFamily="34" charset="-127"/>
                <a:cs typeface="Arial" panose="020B0604020202020204" pitchFamily="34" charset="0"/>
              </a:endParaRPr>
            </a:p>
          </p:txBody>
        </p:sp>
      </p:grpSp>
      <p:sp>
        <p:nvSpPr>
          <p:cNvPr id="30" name="テキスト ボックス 29"/>
          <p:cNvSpPr txBox="1"/>
          <p:nvPr/>
        </p:nvSpPr>
        <p:spPr>
          <a:xfrm flipH="1">
            <a:off x="1206296" y="702321"/>
            <a:ext cx="1533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cs typeface="Arial" panose="020B0604020202020204" pitchFamily="34" charset="0"/>
              </a:rPr>
              <a:t>WCS0897G21</a:t>
            </a:r>
            <a:r>
              <a:rPr lang="ja-JP" altLang="en-US" sz="1600" b="1" dirty="0" smtClean="0">
                <a:cs typeface="Arial" panose="020B0604020202020204" pitchFamily="34" charset="0"/>
              </a:rPr>
              <a:t>　</a:t>
            </a:r>
            <a:endParaRPr lang="en-US" altLang="ja-JP" sz="1600" b="1" dirty="0" smtClean="0"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 flipH="1">
            <a:off x="1226994" y="1341090"/>
            <a:ext cx="14980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 smtClean="0">
                <a:cs typeface="Arial" panose="020B0604020202020204" pitchFamily="34" charset="0"/>
              </a:rPr>
              <a:t>WCS0334P24</a:t>
            </a:r>
            <a:r>
              <a:rPr lang="ja-JP" altLang="en-US" sz="1600" b="1" dirty="0" smtClean="0">
                <a:cs typeface="Arial" panose="020B0604020202020204" pitchFamily="34" charset="0"/>
              </a:rPr>
              <a:t>　</a:t>
            </a:r>
            <a:endParaRPr lang="en-US" altLang="ja-JP" sz="1600" b="1" dirty="0" smtClean="0">
              <a:cs typeface="Arial" panose="020B0604020202020204" pitchFamily="34" charset="0"/>
            </a:endParaRPr>
          </a:p>
        </p:txBody>
      </p:sp>
      <p:cxnSp>
        <p:nvCxnSpPr>
          <p:cNvPr id="32" name="直線矢印コネクタ 31"/>
          <p:cNvCxnSpPr/>
          <p:nvPr/>
        </p:nvCxnSpPr>
        <p:spPr>
          <a:xfrm>
            <a:off x="4581779" y="1883103"/>
            <a:ext cx="230430" cy="0"/>
          </a:xfrm>
          <a:prstGeom prst="straightConnector1">
            <a:avLst/>
          </a:prstGeom>
          <a:ln w="28575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 rot="10800000">
            <a:off x="5979547" y="1892628"/>
            <a:ext cx="230430" cy="0"/>
          </a:xfrm>
          <a:prstGeom prst="straightConnector1">
            <a:avLst/>
          </a:prstGeom>
          <a:ln w="28575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20"/>
          <p:cNvSpPr txBox="1">
            <a:spLocks noChangeArrowheads="1"/>
          </p:cNvSpPr>
          <p:nvPr/>
        </p:nvSpPr>
        <p:spPr bwMode="auto">
          <a:xfrm>
            <a:off x="2977833" y="1764655"/>
            <a:ext cx="158560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334P24-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1-1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21"/>
          <p:cNvSpPr txBox="1">
            <a:spLocks noChangeArrowheads="1"/>
          </p:cNvSpPr>
          <p:nvPr/>
        </p:nvSpPr>
        <p:spPr bwMode="auto">
          <a:xfrm>
            <a:off x="6261627" y="1751902"/>
            <a:ext cx="15708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334P24-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1-2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" name="グループ化 35"/>
          <p:cNvGrpSpPr/>
          <p:nvPr/>
        </p:nvGrpSpPr>
        <p:grpSpPr>
          <a:xfrm>
            <a:off x="2843808" y="724981"/>
            <a:ext cx="4312366" cy="936104"/>
            <a:chOff x="574300" y="692696"/>
            <a:chExt cx="5941838" cy="1482473"/>
          </a:xfrm>
        </p:grpSpPr>
        <p:sp>
          <p:nvSpPr>
            <p:cNvPr id="37" name="正方形/長方形 36"/>
            <p:cNvSpPr/>
            <p:nvPr/>
          </p:nvSpPr>
          <p:spPr>
            <a:xfrm>
              <a:off x="1058738" y="1851319"/>
              <a:ext cx="1873250" cy="32385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線コネクタ 37"/>
            <p:cNvCxnSpPr/>
            <p:nvPr/>
          </p:nvCxnSpPr>
          <p:spPr>
            <a:xfrm>
              <a:off x="576138" y="2013244"/>
              <a:ext cx="5940000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正方形/長方形 38"/>
            <p:cNvSpPr/>
            <p:nvPr/>
          </p:nvSpPr>
          <p:spPr>
            <a:xfrm>
              <a:off x="5002088" y="1851319"/>
              <a:ext cx="1223963" cy="32385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正方形/長方形 39"/>
            <p:cNvSpPr/>
            <p:nvPr/>
          </p:nvSpPr>
          <p:spPr>
            <a:xfrm>
              <a:off x="1056900" y="692696"/>
              <a:ext cx="1873250" cy="32385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線コネクタ 40"/>
            <p:cNvCxnSpPr/>
            <p:nvPr/>
          </p:nvCxnSpPr>
          <p:spPr>
            <a:xfrm>
              <a:off x="574300" y="854621"/>
              <a:ext cx="5040000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正方形/長方形 41"/>
            <p:cNvSpPr/>
            <p:nvPr/>
          </p:nvSpPr>
          <p:spPr>
            <a:xfrm>
              <a:off x="4039280" y="692696"/>
              <a:ext cx="1223963" cy="32385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二等辺三角形 42"/>
            <p:cNvSpPr/>
            <p:nvPr/>
          </p:nvSpPr>
          <p:spPr>
            <a:xfrm>
              <a:off x="3299244" y="854621"/>
              <a:ext cx="1000918" cy="1172072"/>
            </a:xfrm>
            <a:prstGeom prst="triangle">
              <a:avLst>
                <a:gd name="adj" fmla="val 0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フリーフォーム 43"/>
            <p:cNvSpPr/>
            <p:nvPr/>
          </p:nvSpPr>
          <p:spPr>
            <a:xfrm>
              <a:off x="3635896" y="818866"/>
              <a:ext cx="1133997" cy="1207827"/>
            </a:xfrm>
            <a:custGeom>
              <a:avLst/>
              <a:gdLst>
                <a:gd name="connsiteX0" fmla="*/ 0 w 1050878"/>
                <a:gd name="connsiteY0" fmla="*/ 0 h 1173708"/>
                <a:gd name="connsiteX1" fmla="*/ 948519 w 1050878"/>
                <a:gd name="connsiteY1" fmla="*/ 1173708 h 1173708"/>
                <a:gd name="connsiteX2" fmla="*/ 1050878 w 1050878"/>
                <a:gd name="connsiteY2" fmla="*/ 1173708 h 1173708"/>
                <a:gd name="connsiteX3" fmla="*/ 0 w 1050878"/>
                <a:gd name="connsiteY3" fmla="*/ 0 h 11737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50878" h="1173708">
                  <a:moveTo>
                    <a:pt x="0" y="0"/>
                  </a:moveTo>
                  <a:lnTo>
                    <a:pt x="948519" y="1173708"/>
                  </a:lnTo>
                  <a:lnTo>
                    <a:pt x="1050878" y="117370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テキスト ボックス 44"/>
          <p:cNvSpPr txBox="1"/>
          <p:nvPr/>
        </p:nvSpPr>
        <p:spPr>
          <a:xfrm>
            <a:off x="3366520" y="1001324"/>
            <a:ext cx="1038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cs typeface="Arial" panose="020B0604020202020204" pitchFamily="34" charset="0"/>
              </a:rPr>
              <a:t>Exon</a:t>
            </a:r>
            <a:r>
              <a:rPr lang="ja-JP" altLang="en-US" dirty="0">
                <a:cs typeface="Arial" panose="020B0604020202020204" pitchFamily="34" charset="0"/>
              </a:rPr>
              <a:t> </a:t>
            </a:r>
            <a:r>
              <a:rPr kumimoji="1" lang="en-US" altLang="ja-JP" dirty="0" smtClean="0">
                <a:cs typeface="Arial" panose="020B0604020202020204" pitchFamily="34" charset="0"/>
              </a:rPr>
              <a:t>15</a:t>
            </a:r>
            <a:endParaRPr kumimoji="1" lang="ja-JP" altLang="en-US" dirty="0"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898065" y="992566"/>
            <a:ext cx="1047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cs typeface="Arial" panose="020B0604020202020204" pitchFamily="34" charset="0"/>
              </a:rPr>
              <a:t>Exon</a:t>
            </a:r>
            <a:r>
              <a:rPr lang="ja-JP" altLang="en-US" dirty="0" smtClean="0">
                <a:cs typeface="Arial" panose="020B0604020202020204" pitchFamily="34" charset="0"/>
              </a:rPr>
              <a:t> </a:t>
            </a:r>
            <a:r>
              <a:rPr kumimoji="1" lang="en-US" altLang="ja-JP" dirty="0" smtClean="0">
                <a:cs typeface="Arial" panose="020B0604020202020204" pitchFamily="34" charset="0"/>
              </a:rPr>
              <a:t>14</a:t>
            </a:r>
            <a:endParaRPr kumimoji="1" lang="ja-JP" altLang="en-US" dirty="0"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4502640" y="305819"/>
            <a:ext cx="12236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cs typeface="Arial" panose="020B0604020202020204" pitchFamily="34" charset="0"/>
              </a:rPr>
              <a:t>Intron</a:t>
            </a:r>
            <a:r>
              <a:rPr lang="ja-JP" altLang="en-US" dirty="0" smtClean="0">
                <a:cs typeface="Arial" panose="020B0604020202020204" pitchFamily="34" charset="0"/>
              </a:rPr>
              <a:t> </a:t>
            </a:r>
            <a:r>
              <a:rPr kumimoji="1" lang="en-US" altLang="ja-JP" dirty="0" smtClean="0">
                <a:cs typeface="Arial" panose="020B0604020202020204" pitchFamily="34" charset="0"/>
              </a:rPr>
              <a:t>14</a:t>
            </a:r>
            <a:endParaRPr kumimoji="1" lang="ja-JP" altLang="en-US" dirty="0"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726331" y="3928877"/>
            <a:ext cx="1542158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US" altLang="ja-JP" sz="1400" dirty="0" smtClean="0">
                <a:cs typeface="Arial" panose="020B0604020202020204" pitchFamily="34" charset="0"/>
              </a:rPr>
              <a:t>N5AT5B</a:t>
            </a:r>
          </a:p>
          <a:p>
            <a:pPr marL="342900" indent="-342900">
              <a:buFont typeface="+mj-lt"/>
              <a:buAutoNum type="arabicPeriod"/>
            </a:pPr>
            <a:r>
              <a:rPr lang="en-US" altLang="ja-JP" sz="1400" dirty="0" smtClean="0">
                <a:cs typeface="Arial" panose="020B0604020202020204" pitchFamily="34" charset="0"/>
              </a:rPr>
              <a:t>N5AT5D</a:t>
            </a:r>
            <a:endParaRPr lang="en-US" altLang="ja-JP" sz="6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altLang="ja-JP" sz="1400" dirty="0" smtClean="0">
                <a:cs typeface="Arial" panose="020B0604020202020204" pitchFamily="34" charset="0"/>
              </a:rPr>
              <a:t>N5BT5A</a:t>
            </a:r>
            <a:endParaRPr lang="en-US" altLang="ja-JP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altLang="ja-JP" sz="1400" dirty="0" smtClean="0">
                <a:cs typeface="Arial" panose="020B0604020202020204" pitchFamily="34" charset="0"/>
              </a:rPr>
              <a:t>N5BT5D</a:t>
            </a:r>
            <a:endParaRPr lang="en-US" altLang="ja-JP" sz="6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altLang="ja-JP" sz="1400" dirty="0" smtClean="0">
                <a:cs typeface="Arial" panose="020B0604020202020204" pitchFamily="34" charset="0"/>
              </a:rPr>
              <a:t>N5DT5A</a:t>
            </a:r>
            <a:endParaRPr lang="en-US" altLang="ja-JP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altLang="ja-JP" sz="1400" dirty="0" smtClean="0">
                <a:cs typeface="Arial" panose="020B0604020202020204" pitchFamily="34" charset="0"/>
              </a:rPr>
              <a:t>N5DT5B</a:t>
            </a:r>
          </a:p>
          <a:p>
            <a:r>
              <a:rPr lang="en-US" altLang="ja-JP" sz="1400" dirty="0" smtClean="0">
                <a:cs typeface="Arial" panose="020B0604020202020204" pitchFamily="34" charset="0"/>
              </a:rPr>
              <a:t>M    marker</a:t>
            </a:r>
            <a:endParaRPr lang="en-US" altLang="ja-JP" sz="1400" dirty="0"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244461" y="12344"/>
            <a:ext cx="4793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cs typeface="Arial" panose="020B0604020202020204" pitchFamily="34" charset="0"/>
              </a:rPr>
              <a:t>a)</a:t>
            </a:r>
            <a:endParaRPr kumimoji="1" lang="ja-JP" altLang="en-US" sz="2400" b="1" dirty="0"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325733" y="2786402"/>
            <a:ext cx="4793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cs typeface="Arial" panose="020B0604020202020204" pitchFamily="34" charset="0"/>
              </a:rPr>
              <a:t>b)</a:t>
            </a:r>
            <a:endParaRPr kumimoji="1" lang="ja-JP" altLang="en-US" sz="2400" b="1" dirty="0">
              <a:cs typeface="Arial" panose="020B0604020202020204" pitchFamily="34" charset="0"/>
            </a:endParaRPr>
          </a:p>
        </p:txBody>
      </p:sp>
      <p:sp>
        <p:nvSpPr>
          <p:cNvPr id="51" name="正方形/長方形 50"/>
          <p:cNvSpPr/>
          <p:nvPr/>
        </p:nvSpPr>
        <p:spPr>
          <a:xfrm>
            <a:off x="480504" y="5948943"/>
            <a:ext cx="84329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 smtClean="0">
                <a:cs typeface="Arial" panose="020B0604020202020204" pitchFamily="34" charset="0"/>
              </a:rPr>
              <a:t>Figure S1</a:t>
            </a:r>
            <a:r>
              <a:rPr lang="en-US" altLang="ja-JP" sz="1200" b="1" dirty="0">
                <a:cs typeface="Arial" panose="020B0604020202020204" pitchFamily="34" charset="0"/>
              </a:rPr>
              <a:t>. </a:t>
            </a:r>
            <a:r>
              <a:rPr lang="en-US" altLang="ja-JP" sz="1200" b="1" dirty="0"/>
              <a:t>a</a:t>
            </a:r>
            <a:r>
              <a:rPr lang="en-US" altLang="ja-JP" sz="1200" dirty="0"/>
              <a:t> Primer positions (arrows) for clone selection from the Chinese Spring (CS) BAC library. WCS0334P24 has two insertions in intron 14 as indicated by orange wedges. </a:t>
            </a:r>
            <a:r>
              <a:rPr lang="en-US" altLang="ja-JP" sz="1200" b="1" dirty="0"/>
              <a:t>b</a:t>
            </a:r>
            <a:r>
              <a:rPr lang="en-US" altLang="ja-JP" sz="1200" dirty="0"/>
              <a:t> Amplification of DNA samples from a set of </a:t>
            </a:r>
            <a:r>
              <a:rPr lang="en-US" altLang="ja-JP" sz="1200" dirty="0" err="1"/>
              <a:t>nullisomic-tetrasomic</a:t>
            </a:r>
            <a:r>
              <a:rPr lang="en-US" altLang="ja-JP" sz="1200" dirty="0"/>
              <a:t> (NT) lines </a:t>
            </a:r>
            <a:r>
              <a:rPr lang="en-US" altLang="ja-JP" sz="1200" dirty="0" smtClean="0"/>
              <a:t>[19] </a:t>
            </a:r>
            <a:r>
              <a:rPr lang="en-US" altLang="ja-JP" sz="1200" dirty="0"/>
              <a:t>of CS for the </a:t>
            </a:r>
            <a:r>
              <a:rPr lang="en-US" altLang="ja-JP" sz="1200" dirty="0" err="1"/>
              <a:t>homeologous</a:t>
            </a:r>
            <a:r>
              <a:rPr lang="en-US" altLang="ja-JP" sz="1200" dirty="0"/>
              <a:t> group 5 chromosomes.</a:t>
            </a:r>
            <a:endParaRPr lang="ja-JP" altLang="en-US" sz="12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18350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6199" y="5845963"/>
            <a:ext cx="1685119" cy="7102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6989940" y="93927"/>
            <a:ext cx="4319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’</a:t>
            </a:r>
            <a:endParaRPr lang="ja-JP" alt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670921" y="134199"/>
            <a:ext cx="630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A</a:t>
            </a:r>
            <a:endParaRPr lang="ja-JP" altLang="en-US" sz="140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線コネクタ 5"/>
          <p:cNvCxnSpPr/>
          <p:nvPr/>
        </p:nvCxnSpPr>
        <p:spPr>
          <a:xfrm>
            <a:off x="3306625" y="506016"/>
            <a:ext cx="397343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 flipV="1">
            <a:off x="3703968" y="630780"/>
            <a:ext cx="2183754" cy="253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5920152" y="755543"/>
            <a:ext cx="113595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3105352" y="93926"/>
            <a:ext cx="3316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’</a:t>
            </a:r>
            <a:endParaRPr lang="ja-JP" alt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グループ化 9"/>
          <p:cNvGrpSpPr/>
          <p:nvPr/>
        </p:nvGrpSpPr>
        <p:grpSpPr>
          <a:xfrm>
            <a:off x="3275856" y="278382"/>
            <a:ext cx="3812607" cy="124714"/>
            <a:chOff x="830718" y="1423317"/>
            <a:chExt cx="8388000" cy="215938"/>
          </a:xfrm>
          <a:solidFill>
            <a:schemeClr val="tx2">
              <a:lumMod val="60000"/>
              <a:lumOff val="40000"/>
            </a:schemeClr>
          </a:solidFill>
        </p:grpSpPr>
        <p:cxnSp>
          <p:nvCxnSpPr>
            <p:cNvPr id="11" name="直線コネクタ 10"/>
            <p:cNvCxnSpPr/>
            <p:nvPr/>
          </p:nvCxnSpPr>
          <p:spPr>
            <a:xfrm>
              <a:off x="1772594" y="1530263"/>
              <a:ext cx="4089439" cy="0"/>
            </a:xfrm>
            <a:prstGeom prst="line">
              <a:avLst/>
            </a:prstGeom>
            <a:grpFill/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/>
            <p:cNvCxnSpPr/>
            <p:nvPr/>
          </p:nvCxnSpPr>
          <p:spPr>
            <a:xfrm>
              <a:off x="830718" y="1530263"/>
              <a:ext cx="8388000" cy="0"/>
            </a:xfrm>
            <a:prstGeom prst="line">
              <a:avLst/>
            </a:prstGeom>
            <a:grpFill/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正方形/長方形 12"/>
            <p:cNvSpPr/>
            <p:nvPr/>
          </p:nvSpPr>
          <p:spPr>
            <a:xfrm>
              <a:off x="1005015" y="1423317"/>
              <a:ext cx="552967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正方形/長方形 13"/>
            <p:cNvSpPr/>
            <p:nvPr/>
          </p:nvSpPr>
          <p:spPr>
            <a:xfrm>
              <a:off x="2031489" y="1423317"/>
              <a:ext cx="316358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正方形/長方形 14"/>
            <p:cNvSpPr/>
            <p:nvPr/>
          </p:nvSpPr>
          <p:spPr>
            <a:xfrm>
              <a:off x="2575548" y="1423317"/>
              <a:ext cx="133659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正方形/長方形 15"/>
            <p:cNvSpPr/>
            <p:nvPr/>
          </p:nvSpPr>
          <p:spPr>
            <a:xfrm>
              <a:off x="4086518" y="1423317"/>
              <a:ext cx="236802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正方形/長方形 16"/>
            <p:cNvSpPr/>
            <p:nvPr/>
          </p:nvSpPr>
          <p:spPr>
            <a:xfrm>
              <a:off x="4499992" y="1423317"/>
              <a:ext cx="208574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正方形/長方形 17"/>
            <p:cNvSpPr/>
            <p:nvPr/>
          </p:nvSpPr>
          <p:spPr>
            <a:xfrm>
              <a:off x="4850269" y="1423317"/>
              <a:ext cx="119554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正方形/長方形 18"/>
            <p:cNvSpPr/>
            <p:nvPr/>
          </p:nvSpPr>
          <p:spPr>
            <a:xfrm>
              <a:off x="5207751" y="1423317"/>
              <a:ext cx="225209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正方形/長方形 19"/>
            <p:cNvSpPr/>
            <p:nvPr/>
          </p:nvSpPr>
          <p:spPr>
            <a:xfrm>
              <a:off x="5788299" y="1423317"/>
              <a:ext cx="196866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6257646" y="1423317"/>
              <a:ext cx="170003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正方形/長方形 21"/>
            <p:cNvSpPr/>
            <p:nvPr/>
          </p:nvSpPr>
          <p:spPr>
            <a:xfrm>
              <a:off x="6714727" y="1423317"/>
              <a:ext cx="143267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7199039" y="1423317"/>
              <a:ext cx="116155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7468615" y="1423317"/>
              <a:ext cx="107837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正方形/長方形 24"/>
            <p:cNvSpPr/>
            <p:nvPr/>
          </p:nvSpPr>
          <p:spPr>
            <a:xfrm>
              <a:off x="7740669" y="1423317"/>
              <a:ext cx="79227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正方形/長方形 25"/>
            <p:cNvSpPr/>
            <p:nvPr/>
          </p:nvSpPr>
          <p:spPr>
            <a:xfrm>
              <a:off x="8751201" y="1423317"/>
              <a:ext cx="262166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正方形/長方形 26"/>
            <p:cNvSpPr/>
            <p:nvPr/>
          </p:nvSpPr>
          <p:spPr>
            <a:xfrm>
              <a:off x="8518291" y="1425362"/>
              <a:ext cx="79227" cy="213893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00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8" name="直線矢印コネクタ 27"/>
          <p:cNvCxnSpPr/>
          <p:nvPr/>
        </p:nvCxnSpPr>
        <p:spPr>
          <a:xfrm>
            <a:off x="3209078" y="506016"/>
            <a:ext cx="125198" cy="0"/>
          </a:xfrm>
          <a:prstGeom prst="straightConnector1">
            <a:avLst/>
          </a:prstGeom>
          <a:ln w="28575"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 flipH="1">
            <a:off x="3617611" y="506016"/>
            <a:ext cx="117676" cy="0"/>
          </a:xfrm>
          <a:prstGeom prst="straightConnector1">
            <a:avLst/>
          </a:prstGeom>
          <a:ln w="28575"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>
            <a:off x="3606420" y="630780"/>
            <a:ext cx="125198" cy="0"/>
          </a:xfrm>
          <a:prstGeom prst="straightConnector1">
            <a:avLst/>
          </a:prstGeom>
          <a:ln w="28575"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 flipH="1">
            <a:off x="5865205" y="630780"/>
            <a:ext cx="117676" cy="0"/>
          </a:xfrm>
          <a:prstGeom prst="straightConnector1">
            <a:avLst/>
          </a:prstGeom>
          <a:ln w="28575"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/>
          <p:nvPr/>
        </p:nvCxnSpPr>
        <p:spPr>
          <a:xfrm>
            <a:off x="5854822" y="755543"/>
            <a:ext cx="125198" cy="0"/>
          </a:xfrm>
          <a:prstGeom prst="straightConnector1">
            <a:avLst/>
          </a:prstGeom>
          <a:ln w="28575"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 flipH="1">
            <a:off x="7029625" y="755543"/>
            <a:ext cx="117676" cy="0"/>
          </a:xfrm>
          <a:prstGeom prst="straightConnector1">
            <a:avLst/>
          </a:prstGeom>
          <a:ln w="28575"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/>
          <p:cNvSpPr txBox="1"/>
          <p:nvPr/>
        </p:nvSpPr>
        <p:spPr>
          <a:xfrm>
            <a:off x="4628480" y="660506"/>
            <a:ext cx="12263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6</a:t>
            </a:r>
            <a:r>
              <a:rPr lang="ja-JP" altLang="en-US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852</a:t>
            </a:r>
            <a:r>
              <a:rPr lang="ja-JP" altLang="en-US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ja-JP" alt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073245" y="629126"/>
            <a:ext cx="1100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28</a:t>
            </a:r>
            <a:r>
              <a:rPr lang="ja-JP" altLang="en-US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11</a:t>
            </a:r>
            <a:r>
              <a:rPr lang="ja-JP" altLang="en-US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ja-JP" alt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6170456" y="506016"/>
            <a:ext cx="10621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12</a:t>
            </a:r>
            <a:r>
              <a:rPr lang="ja-JP" altLang="en-US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90 </a:t>
            </a:r>
            <a:r>
              <a:rPr lang="en-US" altLang="ja-JP" sz="10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ja-JP" altLang="en-US" sz="1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7" name="グループ化 36"/>
          <p:cNvGrpSpPr/>
          <p:nvPr/>
        </p:nvGrpSpPr>
        <p:grpSpPr>
          <a:xfrm>
            <a:off x="2980785" y="1326445"/>
            <a:ext cx="1570064" cy="774717"/>
            <a:chOff x="1816418" y="2107742"/>
            <a:chExt cx="1570064" cy="774717"/>
          </a:xfrm>
        </p:grpSpPr>
        <p:pic>
          <p:nvPicPr>
            <p:cNvPr id="38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16418" y="2185214"/>
              <a:ext cx="1570064" cy="697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39" name="グループ化 38"/>
            <p:cNvGrpSpPr/>
            <p:nvPr/>
          </p:nvGrpSpPr>
          <p:grpSpPr>
            <a:xfrm>
              <a:off x="2165406" y="2107742"/>
              <a:ext cx="868464" cy="774717"/>
              <a:chOff x="1661423" y="3717032"/>
              <a:chExt cx="1614433" cy="3096000"/>
            </a:xfrm>
          </p:grpSpPr>
          <p:cxnSp>
            <p:nvCxnSpPr>
              <p:cNvPr id="40" name="直線コネクタ 39"/>
              <p:cNvCxnSpPr/>
              <p:nvPr/>
            </p:nvCxnSpPr>
            <p:spPr>
              <a:xfrm>
                <a:off x="1661423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線コネクタ 40"/>
              <p:cNvCxnSpPr/>
              <p:nvPr/>
            </p:nvCxnSpPr>
            <p:spPr>
              <a:xfrm>
                <a:off x="2288640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線コネクタ 41"/>
              <p:cNvCxnSpPr/>
              <p:nvPr/>
            </p:nvCxnSpPr>
            <p:spPr>
              <a:xfrm>
                <a:off x="2951785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線コネクタ 42"/>
              <p:cNvCxnSpPr/>
              <p:nvPr/>
            </p:nvCxnSpPr>
            <p:spPr>
              <a:xfrm>
                <a:off x="3275856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4" name="グループ化 43"/>
          <p:cNvGrpSpPr/>
          <p:nvPr/>
        </p:nvGrpSpPr>
        <p:grpSpPr>
          <a:xfrm>
            <a:off x="7159950" y="1329132"/>
            <a:ext cx="1690741" cy="765781"/>
            <a:chOff x="3950573" y="2107742"/>
            <a:chExt cx="1710468" cy="774716"/>
          </a:xfrm>
        </p:grpSpPr>
        <p:pic>
          <p:nvPicPr>
            <p:cNvPr id="45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50573" y="2166922"/>
              <a:ext cx="1710468" cy="6737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46" name="グループ化 45"/>
            <p:cNvGrpSpPr/>
            <p:nvPr/>
          </p:nvGrpSpPr>
          <p:grpSpPr>
            <a:xfrm>
              <a:off x="4352239" y="2107742"/>
              <a:ext cx="961612" cy="774716"/>
              <a:chOff x="1661423" y="3717032"/>
              <a:chExt cx="1614433" cy="3096000"/>
            </a:xfrm>
          </p:grpSpPr>
          <p:cxnSp>
            <p:nvCxnSpPr>
              <p:cNvPr id="47" name="直線コネクタ 46"/>
              <p:cNvCxnSpPr/>
              <p:nvPr/>
            </p:nvCxnSpPr>
            <p:spPr>
              <a:xfrm>
                <a:off x="1661423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線コネクタ 47"/>
              <p:cNvCxnSpPr/>
              <p:nvPr/>
            </p:nvCxnSpPr>
            <p:spPr>
              <a:xfrm>
                <a:off x="2288640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コネクタ 48"/>
              <p:cNvCxnSpPr/>
              <p:nvPr/>
            </p:nvCxnSpPr>
            <p:spPr>
              <a:xfrm>
                <a:off x="2951785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/>
              <p:cNvCxnSpPr/>
              <p:nvPr/>
            </p:nvCxnSpPr>
            <p:spPr>
              <a:xfrm>
                <a:off x="3275856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1" name="テキスト ボックス 50"/>
          <p:cNvSpPr txBox="1"/>
          <p:nvPr/>
        </p:nvSpPr>
        <p:spPr>
          <a:xfrm>
            <a:off x="2887083" y="1018888"/>
            <a:ext cx="9387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28</a:t>
            </a:r>
            <a:endParaRPr lang="ja-JP" alt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5026094" y="1018888"/>
            <a:ext cx="6907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6</a:t>
            </a:r>
            <a:endParaRPr lang="ja-JP" alt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7078909" y="1018888"/>
            <a:ext cx="91137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12</a:t>
            </a:r>
            <a:endParaRPr lang="ja-JP" alt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4" name="グループ化 53"/>
          <p:cNvGrpSpPr/>
          <p:nvPr/>
        </p:nvGrpSpPr>
        <p:grpSpPr>
          <a:xfrm>
            <a:off x="3288505" y="2268079"/>
            <a:ext cx="4103465" cy="843686"/>
            <a:chOff x="633159" y="3690066"/>
            <a:chExt cx="4103465" cy="843686"/>
          </a:xfrm>
        </p:grpSpPr>
        <p:sp>
          <p:nvSpPr>
            <p:cNvPr id="55" name="テキスト ボックス 54"/>
            <p:cNvSpPr txBox="1"/>
            <p:nvPr/>
          </p:nvSpPr>
          <p:spPr>
            <a:xfrm>
              <a:off x="4389418" y="3690066"/>
              <a:ext cx="3472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’</a:t>
              </a:r>
              <a:endParaRPr lang="ja-JP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633159" y="3730312"/>
              <a:ext cx="3418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lang="ja-JP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7" name="グループ化 56"/>
            <p:cNvGrpSpPr/>
            <p:nvPr/>
          </p:nvGrpSpPr>
          <p:grpSpPr>
            <a:xfrm>
              <a:off x="735425" y="3939508"/>
              <a:ext cx="3815136" cy="124649"/>
              <a:chOff x="830718" y="1423317"/>
              <a:chExt cx="8388000" cy="215938"/>
            </a:xfrm>
            <a:solidFill>
              <a:schemeClr val="tx2">
                <a:lumMod val="60000"/>
                <a:lumOff val="40000"/>
              </a:schemeClr>
            </a:solidFill>
          </p:grpSpPr>
          <p:cxnSp>
            <p:nvCxnSpPr>
              <p:cNvPr id="66" name="直線コネクタ 65"/>
              <p:cNvCxnSpPr/>
              <p:nvPr/>
            </p:nvCxnSpPr>
            <p:spPr>
              <a:xfrm>
                <a:off x="1772594" y="1530263"/>
                <a:ext cx="4089439" cy="0"/>
              </a:xfrm>
              <a:prstGeom prst="line">
                <a:avLst/>
              </a:prstGeom>
              <a:grpFill/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線コネクタ 66"/>
              <p:cNvCxnSpPr/>
              <p:nvPr/>
            </p:nvCxnSpPr>
            <p:spPr>
              <a:xfrm>
                <a:off x="830718" y="1530263"/>
                <a:ext cx="8388000" cy="0"/>
              </a:xfrm>
              <a:prstGeom prst="line">
                <a:avLst/>
              </a:prstGeom>
              <a:grpFill/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正方形/長方形 67"/>
              <p:cNvSpPr/>
              <p:nvPr/>
            </p:nvSpPr>
            <p:spPr>
              <a:xfrm>
                <a:off x="1005015" y="1423317"/>
                <a:ext cx="55296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正方形/長方形 68"/>
              <p:cNvSpPr/>
              <p:nvPr/>
            </p:nvSpPr>
            <p:spPr>
              <a:xfrm>
                <a:off x="2031489" y="1423317"/>
                <a:ext cx="316358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正方形/長方形 69"/>
              <p:cNvSpPr/>
              <p:nvPr/>
            </p:nvSpPr>
            <p:spPr>
              <a:xfrm>
                <a:off x="2575548" y="1423317"/>
                <a:ext cx="133659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正方形/長方形 70"/>
              <p:cNvSpPr/>
              <p:nvPr/>
            </p:nvSpPr>
            <p:spPr>
              <a:xfrm>
                <a:off x="4086518" y="1423317"/>
                <a:ext cx="236802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正方形/長方形 71"/>
              <p:cNvSpPr/>
              <p:nvPr/>
            </p:nvSpPr>
            <p:spPr>
              <a:xfrm>
                <a:off x="4499992" y="1423317"/>
                <a:ext cx="208574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正方形/長方形 72"/>
              <p:cNvSpPr/>
              <p:nvPr/>
            </p:nvSpPr>
            <p:spPr>
              <a:xfrm>
                <a:off x="4850269" y="1423317"/>
                <a:ext cx="119554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正方形/長方形 73"/>
              <p:cNvSpPr/>
              <p:nvPr/>
            </p:nvSpPr>
            <p:spPr>
              <a:xfrm>
                <a:off x="5207751" y="1423317"/>
                <a:ext cx="225209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正方形/長方形 74"/>
              <p:cNvSpPr/>
              <p:nvPr/>
            </p:nvSpPr>
            <p:spPr>
              <a:xfrm>
                <a:off x="5788299" y="1423317"/>
                <a:ext cx="196866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正方形/長方形 75"/>
              <p:cNvSpPr/>
              <p:nvPr/>
            </p:nvSpPr>
            <p:spPr>
              <a:xfrm>
                <a:off x="6252727" y="1423317"/>
                <a:ext cx="170003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正方形/長方形 76"/>
              <p:cNvSpPr/>
              <p:nvPr/>
            </p:nvSpPr>
            <p:spPr>
              <a:xfrm>
                <a:off x="6714727" y="1423317"/>
                <a:ext cx="14326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正方形/長方形 77"/>
              <p:cNvSpPr/>
              <p:nvPr/>
            </p:nvSpPr>
            <p:spPr>
              <a:xfrm>
                <a:off x="7199039" y="1423317"/>
                <a:ext cx="116155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正方形/長方形 78"/>
              <p:cNvSpPr/>
              <p:nvPr/>
            </p:nvSpPr>
            <p:spPr>
              <a:xfrm>
                <a:off x="7468615" y="1423317"/>
                <a:ext cx="10783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正方形/長方形 79"/>
              <p:cNvSpPr/>
              <p:nvPr/>
            </p:nvSpPr>
            <p:spPr>
              <a:xfrm>
                <a:off x="7740669" y="1423317"/>
                <a:ext cx="7922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正方形/長方形 80"/>
              <p:cNvSpPr/>
              <p:nvPr/>
            </p:nvSpPr>
            <p:spPr>
              <a:xfrm>
                <a:off x="8751201" y="1423317"/>
                <a:ext cx="262166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正方形/長方形 81"/>
              <p:cNvSpPr/>
              <p:nvPr/>
            </p:nvSpPr>
            <p:spPr>
              <a:xfrm>
                <a:off x="8518291" y="1425362"/>
                <a:ext cx="7922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58" name="直線矢印コネクタ 57"/>
            <p:cNvCxnSpPr/>
            <p:nvPr/>
          </p:nvCxnSpPr>
          <p:spPr>
            <a:xfrm>
              <a:off x="672785" y="4172839"/>
              <a:ext cx="125281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矢印コネクタ 58"/>
            <p:cNvCxnSpPr/>
            <p:nvPr/>
          </p:nvCxnSpPr>
          <p:spPr>
            <a:xfrm flipH="1">
              <a:off x="3293910" y="4162186"/>
              <a:ext cx="117754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矢印コネクタ 59"/>
            <p:cNvCxnSpPr/>
            <p:nvPr/>
          </p:nvCxnSpPr>
          <p:spPr>
            <a:xfrm>
              <a:off x="3286384" y="4291610"/>
              <a:ext cx="125281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矢印コネクタ 60"/>
            <p:cNvCxnSpPr/>
            <p:nvPr/>
          </p:nvCxnSpPr>
          <p:spPr>
            <a:xfrm flipH="1">
              <a:off x="4491684" y="4292469"/>
              <a:ext cx="117754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/>
            <p:cNvCxnSpPr/>
            <p:nvPr/>
          </p:nvCxnSpPr>
          <p:spPr>
            <a:xfrm flipV="1">
              <a:off x="735425" y="4162186"/>
              <a:ext cx="2559606" cy="1065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/>
            <p:cNvCxnSpPr/>
            <p:nvPr/>
          </p:nvCxnSpPr>
          <p:spPr>
            <a:xfrm>
              <a:off x="3411664" y="4292469"/>
              <a:ext cx="1106519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テキスト ボックス 63"/>
            <p:cNvSpPr txBox="1"/>
            <p:nvPr/>
          </p:nvSpPr>
          <p:spPr>
            <a:xfrm>
              <a:off x="1572483" y="4157666"/>
              <a:ext cx="11122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r>
                <a:rPr lang="ja-JP" altLang="en-US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</a:t>
              </a:r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246</a:t>
              </a:r>
              <a:r>
                <a:rPr lang="ja-JP" altLang="en-US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000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ja-JP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3560184" y="4287531"/>
              <a:ext cx="1086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3</a:t>
              </a:r>
              <a:r>
                <a:rPr lang="ja-JP" altLang="en-US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</a:t>
              </a:r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655 </a:t>
              </a:r>
              <a:r>
                <a:rPr lang="en-US" altLang="ja-JP" sz="1000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ja-JP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83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5730" y="3511224"/>
            <a:ext cx="1581779" cy="707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4" name="Picture 3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301"/>
          <a:stretch/>
        </p:blipFill>
        <p:spPr bwMode="auto">
          <a:xfrm>
            <a:off x="5178997" y="3511224"/>
            <a:ext cx="1575470" cy="707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85" name="グループ化 84"/>
          <p:cNvGrpSpPr/>
          <p:nvPr/>
        </p:nvGrpSpPr>
        <p:grpSpPr>
          <a:xfrm>
            <a:off x="3364923" y="3442736"/>
            <a:ext cx="898445" cy="843011"/>
            <a:chOff x="1661423" y="3717032"/>
            <a:chExt cx="1614433" cy="3096000"/>
          </a:xfrm>
        </p:grpSpPr>
        <p:cxnSp>
          <p:nvCxnSpPr>
            <p:cNvPr id="86" name="直線コネクタ 85"/>
            <p:cNvCxnSpPr/>
            <p:nvPr/>
          </p:nvCxnSpPr>
          <p:spPr>
            <a:xfrm>
              <a:off x="1661423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/>
            <p:cNvCxnSpPr/>
            <p:nvPr/>
          </p:nvCxnSpPr>
          <p:spPr>
            <a:xfrm>
              <a:off x="2288640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/>
            <p:cNvCxnSpPr/>
            <p:nvPr/>
          </p:nvCxnSpPr>
          <p:spPr>
            <a:xfrm>
              <a:off x="2951785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/>
            <p:cNvCxnSpPr/>
            <p:nvPr/>
          </p:nvCxnSpPr>
          <p:spPr>
            <a:xfrm>
              <a:off x="3275856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グループ化 89"/>
          <p:cNvGrpSpPr/>
          <p:nvPr/>
        </p:nvGrpSpPr>
        <p:grpSpPr>
          <a:xfrm>
            <a:off x="5512445" y="3461977"/>
            <a:ext cx="898445" cy="843011"/>
            <a:chOff x="1661423" y="3717032"/>
            <a:chExt cx="1614433" cy="3096000"/>
          </a:xfrm>
        </p:grpSpPr>
        <p:cxnSp>
          <p:nvCxnSpPr>
            <p:cNvPr id="91" name="直線コネクタ 90"/>
            <p:cNvCxnSpPr/>
            <p:nvPr/>
          </p:nvCxnSpPr>
          <p:spPr>
            <a:xfrm>
              <a:off x="1661423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/>
            <p:cNvCxnSpPr/>
            <p:nvPr/>
          </p:nvCxnSpPr>
          <p:spPr>
            <a:xfrm>
              <a:off x="2288640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/>
            <p:cNvCxnSpPr/>
            <p:nvPr/>
          </p:nvCxnSpPr>
          <p:spPr>
            <a:xfrm>
              <a:off x="2951785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/>
            <p:cNvCxnSpPr/>
            <p:nvPr/>
          </p:nvCxnSpPr>
          <p:spPr>
            <a:xfrm>
              <a:off x="3275856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5" name="テキスト ボックス 94"/>
          <p:cNvSpPr txBox="1"/>
          <p:nvPr/>
        </p:nvSpPr>
        <p:spPr>
          <a:xfrm>
            <a:off x="3008058" y="3082911"/>
            <a:ext cx="4296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5109350" y="3115435"/>
            <a:ext cx="4812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3</a:t>
            </a:r>
            <a:endParaRPr lang="ja-JP" alt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7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8674" y="5845963"/>
            <a:ext cx="1583254" cy="7102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99" name="グループ化 98"/>
          <p:cNvGrpSpPr/>
          <p:nvPr/>
        </p:nvGrpSpPr>
        <p:grpSpPr>
          <a:xfrm>
            <a:off x="3330286" y="5788139"/>
            <a:ext cx="927937" cy="870685"/>
            <a:chOff x="1661423" y="3717032"/>
            <a:chExt cx="1614433" cy="3096000"/>
          </a:xfrm>
        </p:grpSpPr>
        <p:cxnSp>
          <p:nvCxnSpPr>
            <p:cNvPr id="100" name="直線コネクタ 99"/>
            <p:cNvCxnSpPr/>
            <p:nvPr/>
          </p:nvCxnSpPr>
          <p:spPr>
            <a:xfrm>
              <a:off x="1661423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線コネクタ 100"/>
            <p:cNvCxnSpPr/>
            <p:nvPr/>
          </p:nvCxnSpPr>
          <p:spPr>
            <a:xfrm>
              <a:off x="2288640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コネクタ 101"/>
            <p:cNvCxnSpPr/>
            <p:nvPr/>
          </p:nvCxnSpPr>
          <p:spPr>
            <a:xfrm>
              <a:off x="2951785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コネクタ 102"/>
            <p:cNvCxnSpPr/>
            <p:nvPr/>
          </p:nvCxnSpPr>
          <p:spPr>
            <a:xfrm>
              <a:off x="3275856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4" name="グループ化 103"/>
          <p:cNvGrpSpPr/>
          <p:nvPr/>
        </p:nvGrpSpPr>
        <p:grpSpPr>
          <a:xfrm>
            <a:off x="5435708" y="5798360"/>
            <a:ext cx="927937" cy="870685"/>
            <a:chOff x="1661423" y="3717032"/>
            <a:chExt cx="1614433" cy="3096000"/>
          </a:xfrm>
        </p:grpSpPr>
        <p:cxnSp>
          <p:nvCxnSpPr>
            <p:cNvPr id="105" name="直線コネクタ 104"/>
            <p:cNvCxnSpPr/>
            <p:nvPr/>
          </p:nvCxnSpPr>
          <p:spPr>
            <a:xfrm>
              <a:off x="1661423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コネクタ 105"/>
            <p:cNvCxnSpPr/>
            <p:nvPr/>
          </p:nvCxnSpPr>
          <p:spPr>
            <a:xfrm>
              <a:off x="2288640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コネクタ 106"/>
            <p:cNvCxnSpPr/>
            <p:nvPr/>
          </p:nvCxnSpPr>
          <p:spPr>
            <a:xfrm>
              <a:off x="2951785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コネクタ 107"/>
            <p:cNvCxnSpPr/>
            <p:nvPr/>
          </p:nvCxnSpPr>
          <p:spPr>
            <a:xfrm>
              <a:off x="3275856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9" name="テキスト ボックス 108"/>
          <p:cNvSpPr txBox="1"/>
          <p:nvPr/>
        </p:nvSpPr>
        <p:spPr>
          <a:xfrm>
            <a:off x="2901398" y="5411930"/>
            <a:ext cx="5620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7</a:t>
            </a:r>
            <a:endParaRPr lang="ja-JP" alt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5090827" y="5445524"/>
            <a:ext cx="5430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36</a:t>
            </a:r>
            <a:endParaRPr lang="ja-JP" alt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2675196" y="4625807"/>
            <a:ext cx="5314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D</a:t>
            </a:r>
          </a:p>
        </p:txBody>
      </p:sp>
      <p:grpSp>
        <p:nvGrpSpPr>
          <p:cNvPr id="112" name="グループ化 111"/>
          <p:cNvGrpSpPr/>
          <p:nvPr/>
        </p:nvGrpSpPr>
        <p:grpSpPr>
          <a:xfrm>
            <a:off x="3250139" y="4547834"/>
            <a:ext cx="4187031" cy="895580"/>
            <a:chOff x="653331" y="6421622"/>
            <a:chExt cx="4187031" cy="895580"/>
          </a:xfrm>
        </p:grpSpPr>
        <p:cxnSp>
          <p:nvCxnSpPr>
            <p:cNvPr id="113" name="直線コネクタ 112"/>
            <p:cNvCxnSpPr/>
            <p:nvPr/>
          </p:nvCxnSpPr>
          <p:spPr>
            <a:xfrm>
              <a:off x="880181" y="6825628"/>
              <a:ext cx="2078016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テキスト ボックス 114"/>
            <p:cNvSpPr txBox="1"/>
            <p:nvPr/>
          </p:nvSpPr>
          <p:spPr>
            <a:xfrm>
              <a:off x="4416396" y="6421622"/>
              <a:ext cx="4239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’</a:t>
              </a:r>
              <a:endParaRPr lang="ja-JP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テキスト ボックス 115"/>
            <p:cNvSpPr txBox="1"/>
            <p:nvPr/>
          </p:nvSpPr>
          <p:spPr>
            <a:xfrm>
              <a:off x="653331" y="6433865"/>
              <a:ext cx="3944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lang="ja-JP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7" name="グループ化 116"/>
            <p:cNvGrpSpPr/>
            <p:nvPr/>
          </p:nvGrpSpPr>
          <p:grpSpPr>
            <a:xfrm>
              <a:off x="822688" y="6590570"/>
              <a:ext cx="3752193" cy="124649"/>
              <a:chOff x="830718" y="1423317"/>
              <a:chExt cx="8388000" cy="215938"/>
            </a:xfrm>
            <a:solidFill>
              <a:schemeClr val="tx2">
                <a:lumMod val="60000"/>
                <a:lumOff val="40000"/>
              </a:schemeClr>
            </a:solidFill>
          </p:grpSpPr>
          <p:cxnSp>
            <p:nvCxnSpPr>
              <p:cNvPr id="128" name="直線コネクタ 127"/>
              <p:cNvCxnSpPr/>
              <p:nvPr/>
            </p:nvCxnSpPr>
            <p:spPr>
              <a:xfrm>
                <a:off x="1772594" y="1530263"/>
                <a:ext cx="4089439" cy="0"/>
              </a:xfrm>
              <a:prstGeom prst="line">
                <a:avLst/>
              </a:prstGeom>
              <a:grpFill/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直線コネクタ 128"/>
              <p:cNvCxnSpPr/>
              <p:nvPr/>
            </p:nvCxnSpPr>
            <p:spPr>
              <a:xfrm>
                <a:off x="830718" y="1530263"/>
                <a:ext cx="8388000" cy="0"/>
              </a:xfrm>
              <a:prstGeom prst="line">
                <a:avLst/>
              </a:prstGeom>
              <a:grpFill/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0" name="正方形/長方形 129"/>
              <p:cNvSpPr/>
              <p:nvPr/>
            </p:nvSpPr>
            <p:spPr>
              <a:xfrm>
                <a:off x="1005015" y="1423317"/>
                <a:ext cx="55296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正方形/長方形 130"/>
              <p:cNvSpPr/>
              <p:nvPr/>
            </p:nvSpPr>
            <p:spPr>
              <a:xfrm>
                <a:off x="2031489" y="1423317"/>
                <a:ext cx="316358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正方形/長方形 131"/>
              <p:cNvSpPr/>
              <p:nvPr/>
            </p:nvSpPr>
            <p:spPr>
              <a:xfrm>
                <a:off x="2575548" y="1423317"/>
                <a:ext cx="133659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正方形/長方形 132"/>
              <p:cNvSpPr/>
              <p:nvPr/>
            </p:nvSpPr>
            <p:spPr>
              <a:xfrm>
                <a:off x="4086518" y="1423317"/>
                <a:ext cx="236802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正方形/長方形 133"/>
              <p:cNvSpPr/>
              <p:nvPr/>
            </p:nvSpPr>
            <p:spPr>
              <a:xfrm>
                <a:off x="4499992" y="1423317"/>
                <a:ext cx="208574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正方形/長方形 134"/>
              <p:cNvSpPr/>
              <p:nvPr/>
            </p:nvSpPr>
            <p:spPr>
              <a:xfrm>
                <a:off x="4850269" y="1423317"/>
                <a:ext cx="119554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正方形/長方形 135"/>
              <p:cNvSpPr/>
              <p:nvPr/>
            </p:nvSpPr>
            <p:spPr>
              <a:xfrm>
                <a:off x="5207751" y="1423317"/>
                <a:ext cx="225209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正方形/長方形 136"/>
              <p:cNvSpPr/>
              <p:nvPr/>
            </p:nvSpPr>
            <p:spPr>
              <a:xfrm>
                <a:off x="5788299" y="1423317"/>
                <a:ext cx="196866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正方形/長方形 137"/>
              <p:cNvSpPr/>
              <p:nvPr/>
            </p:nvSpPr>
            <p:spPr>
              <a:xfrm>
                <a:off x="6250705" y="1423317"/>
                <a:ext cx="170003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正方形/長方形 138"/>
              <p:cNvSpPr/>
              <p:nvPr/>
            </p:nvSpPr>
            <p:spPr>
              <a:xfrm>
                <a:off x="6714727" y="1423317"/>
                <a:ext cx="14326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正方形/長方形 139"/>
              <p:cNvSpPr/>
              <p:nvPr/>
            </p:nvSpPr>
            <p:spPr>
              <a:xfrm>
                <a:off x="7199039" y="1423317"/>
                <a:ext cx="116155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正方形/長方形 140"/>
              <p:cNvSpPr/>
              <p:nvPr/>
            </p:nvSpPr>
            <p:spPr>
              <a:xfrm>
                <a:off x="7468615" y="1423317"/>
                <a:ext cx="10783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正方形/長方形 141"/>
              <p:cNvSpPr/>
              <p:nvPr/>
            </p:nvSpPr>
            <p:spPr>
              <a:xfrm>
                <a:off x="7740669" y="1423317"/>
                <a:ext cx="7922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正方形/長方形 142"/>
              <p:cNvSpPr/>
              <p:nvPr/>
            </p:nvSpPr>
            <p:spPr>
              <a:xfrm>
                <a:off x="8751201" y="1423317"/>
                <a:ext cx="262166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正方形/長方形 143"/>
              <p:cNvSpPr/>
              <p:nvPr/>
            </p:nvSpPr>
            <p:spPr>
              <a:xfrm>
                <a:off x="8518291" y="1425362"/>
                <a:ext cx="79227" cy="213893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00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18" name="直線矢印コネクタ 117"/>
            <p:cNvCxnSpPr/>
            <p:nvPr/>
          </p:nvCxnSpPr>
          <p:spPr>
            <a:xfrm>
              <a:off x="756967" y="6825628"/>
              <a:ext cx="123214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矢印コネクタ 118"/>
            <p:cNvCxnSpPr/>
            <p:nvPr/>
          </p:nvCxnSpPr>
          <p:spPr>
            <a:xfrm flipH="1">
              <a:off x="2900292" y="6825628"/>
              <a:ext cx="115811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テキスト ボックス 121"/>
            <p:cNvSpPr txBox="1"/>
            <p:nvPr/>
          </p:nvSpPr>
          <p:spPr>
            <a:xfrm>
              <a:off x="1561866" y="6819578"/>
              <a:ext cx="8722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7</a:t>
              </a:r>
              <a:r>
                <a:rPr lang="ja-JP" altLang="en-US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　</a:t>
              </a:r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674 </a:t>
              </a:r>
              <a:r>
                <a:rPr lang="en-US" altLang="ja-JP" sz="1000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ja-JP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テキスト ボックス 122"/>
            <p:cNvSpPr txBox="1"/>
            <p:nvPr/>
          </p:nvSpPr>
          <p:spPr>
            <a:xfrm>
              <a:off x="2148295" y="7070981"/>
              <a:ext cx="11978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36  2278 </a:t>
              </a:r>
              <a:r>
                <a:rPr lang="en-US" altLang="ja-JP" sz="1000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ja-JP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4" name="直線矢印コネクタ 123"/>
            <p:cNvCxnSpPr/>
            <p:nvPr/>
          </p:nvCxnSpPr>
          <p:spPr>
            <a:xfrm flipH="1">
              <a:off x="4494335" y="6912010"/>
              <a:ext cx="115811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テキスト ボックス 124"/>
            <p:cNvSpPr txBox="1"/>
            <p:nvPr/>
          </p:nvSpPr>
          <p:spPr>
            <a:xfrm>
              <a:off x="3368803" y="6897310"/>
              <a:ext cx="10030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11  2188 </a:t>
              </a:r>
              <a:r>
                <a:rPr lang="en-US" altLang="ja-JP" sz="1000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ja-JP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6" name="直線コネクタ 125"/>
            <p:cNvCxnSpPr/>
            <p:nvPr/>
          </p:nvCxnSpPr>
          <p:spPr>
            <a:xfrm>
              <a:off x="2994736" y="6912010"/>
              <a:ext cx="1550778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線矢印コネクタ 126"/>
            <p:cNvCxnSpPr/>
            <p:nvPr/>
          </p:nvCxnSpPr>
          <p:spPr>
            <a:xfrm>
              <a:off x="2950125" y="6908387"/>
              <a:ext cx="123214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直線矢印コネクタ 270"/>
            <p:cNvCxnSpPr/>
            <p:nvPr/>
          </p:nvCxnSpPr>
          <p:spPr>
            <a:xfrm flipH="1">
              <a:off x="3355226" y="7104575"/>
              <a:ext cx="115811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直線矢印コネクタ 273"/>
            <p:cNvCxnSpPr/>
            <p:nvPr/>
          </p:nvCxnSpPr>
          <p:spPr>
            <a:xfrm>
              <a:off x="1505707" y="7103415"/>
              <a:ext cx="123214" cy="0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直線コネクタ 274"/>
            <p:cNvCxnSpPr/>
            <p:nvPr/>
          </p:nvCxnSpPr>
          <p:spPr>
            <a:xfrm>
              <a:off x="1608480" y="7103415"/>
              <a:ext cx="175879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5" name="グループ化 144"/>
          <p:cNvGrpSpPr/>
          <p:nvPr/>
        </p:nvGrpSpPr>
        <p:grpSpPr>
          <a:xfrm>
            <a:off x="5109473" y="1325174"/>
            <a:ext cx="1588517" cy="866926"/>
            <a:chOff x="1797965" y="2882459"/>
            <a:chExt cx="1588517" cy="866926"/>
          </a:xfrm>
        </p:grpSpPr>
        <p:pic>
          <p:nvPicPr>
            <p:cNvPr id="146" name="Picture 3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97965" y="2959930"/>
              <a:ext cx="1588517" cy="7843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47" name="グループ化 146"/>
            <p:cNvGrpSpPr/>
            <p:nvPr/>
          </p:nvGrpSpPr>
          <p:grpSpPr>
            <a:xfrm>
              <a:off x="2165324" y="2882459"/>
              <a:ext cx="868464" cy="866926"/>
              <a:chOff x="1661423" y="3717032"/>
              <a:chExt cx="1614433" cy="3096000"/>
            </a:xfrm>
          </p:grpSpPr>
          <p:cxnSp>
            <p:nvCxnSpPr>
              <p:cNvPr id="148" name="直線コネクタ 147"/>
              <p:cNvCxnSpPr/>
              <p:nvPr/>
            </p:nvCxnSpPr>
            <p:spPr>
              <a:xfrm>
                <a:off x="1661423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直線コネクタ 148"/>
              <p:cNvCxnSpPr/>
              <p:nvPr/>
            </p:nvCxnSpPr>
            <p:spPr>
              <a:xfrm>
                <a:off x="2288640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直線コネクタ 149"/>
              <p:cNvCxnSpPr/>
              <p:nvPr/>
            </p:nvCxnSpPr>
            <p:spPr>
              <a:xfrm>
                <a:off x="2951785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直線コネクタ 150"/>
              <p:cNvCxnSpPr/>
              <p:nvPr/>
            </p:nvCxnSpPr>
            <p:spPr>
              <a:xfrm>
                <a:off x="3275856" y="3717032"/>
                <a:ext cx="0" cy="3096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52" name="テキスト ボックス 151"/>
          <p:cNvSpPr txBox="1"/>
          <p:nvPr/>
        </p:nvSpPr>
        <p:spPr>
          <a:xfrm>
            <a:off x="2665619" y="2382145"/>
            <a:ext cx="630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B</a:t>
            </a:r>
            <a:endParaRPr lang="ja-JP" altLang="en-US" sz="140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3" name="グループ化 152"/>
          <p:cNvGrpSpPr/>
          <p:nvPr/>
        </p:nvGrpSpPr>
        <p:grpSpPr>
          <a:xfrm>
            <a:off x="3150195" y="3292413"/>
            <a:ext cx="1513893" cy="261610"/>
            <a:chOff x="1001747" y="4343357"/>
            <a:chExt cx="1513893" cy="261610"/>
          </a:xfrm>
        </p:grpSpPr>
        <p:sp>
          <p:nvSpPr>
            <p:cNvPr id="154" name="テキスト ボックス 153"/>
            <p:cNvSpPr txBox="1"/>
            <p:nvPr/>
          </p:nvSpPr>
          <p:spPr>
            <a:xfrm>
              <a:off x="100174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テキスト ボックス 154"/>
            <p:cNvSpPr txBox="1"/>
            <p:nvPr/>
          </p:nvSpPr>
          <p:spPr>
            <a:xfrm>
              <a:off x="118073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テキスト ボックス 155"/>
            <p:cNvSpPr txBox="1"/>
            <p:nvPr/>
          </p:nvSpPr>
          <p:spPr>
            <a:xfrm>
              <a:off x="135971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テキスト ボックス 156"/>
            <p:cNvSpPr txBox="1"/>
            <p:nvPr/>
          </p:nvSpPr>
          <p:spPr>
            <a:xfrm>
              <a:off x="1538705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テキスト ボックス 157"/>
            <p:cNvSpPr txBox="1"/>
            <p:nvPr/>
          </p:nvSpPr>
          <p:spPr>
            <a:xfrm>
              <a:off x="1717691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テキスト ボックス 158"/>
            <p:cNvSpPr txBox="1"/>
            <p:nvPr/>
          </p:nvSpPr>
          <p:spPr>
            <a:xfrm>
              <a:off x="189667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テキスト ボックス 159"/>
            <p:cNvSpPr txBox="1"/>
            <p:nvPr/>
          </p:nvSpPr>
          <p:spPr>
            <a:xfrm>
              <a:off x="207566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テキスト ボックス 160"/>
            <p:cNvSpPr txBox="1"/>
            <p:nvPr/>
          </p:nvSpPr>
          <p:spPr>
            <a:xfrm>
              <a:off x="225464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2" name="グループ化 161"/>
          <p:cNvGrpSpPr/>
          <p:nvPr/>
        </p:nvGrpSpPr>
        <p:grpSpPr>
          <a:xfrm>
            <a:off x="5293996" y="3298727"/>
            <a:ext cx="1513893" cy="261610"/>
            <a:chOff x="1001747" y="4343357"/>
            <a:chExt cx="1513893" cy="261610"/>
          </a:xfrm>
        </p:grpSpPr>
        <p:sp>
          <p:nvSpPr>
            <p:cNvPr id="163" name="テキスト ボックス 162"/>
            <p:cNvSpPr txBox="1"/>
            <p:nvPr/>
          </p:nvSpPr>
          <p:spPr>
            <a:xfrm>
              <a:off x="100174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テキスト ボックス 163"/>
            <p:cNvSpPr txBox="1"/>
            <p:nvPr/>
          </p:nvSpPr>
          <p:spPr>
            <a:xfrm>
              <a:off x="118073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テキスト ボックス 164"/>
            <p:cNvSpPr txBox="1"/>
            <p:nvPr/>
          </p:nvSpPr>
          <p:spPr>
            <a:xfrm>
              <a:off x="135971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テキスト ボックス 165"/>
            <p:cNvSpPr txBox="1"/>
            <p:nvPr/>
          </p:nvSpPr>
          <p:spPr>
            <a:xfrm>
              <a:off x="1538705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テキスト ボックス 166"/>
            <p:cNvSpPr txBox="1"/>
            <p:nvPr/>
          </p:nvSpPr>
          <p:spPr>
            <a:xfrm>
              <a:off x="1717691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テキスト ボックス 167"/>
            <p:cNvSpPr txBox="1"/>
            <p:nvPr/>
          </p:nvSpPr>
          <p:spPr>
            <a:xfrm>
              <a:off x="189667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テキスト ボックス 168"/>
            <p:cNvSpPr txBox="1"/>
            <p:nvPr/>
          </p:nvSpPr>
          <p:spPr>
            <a:xfrm>
              <a:off x="207566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テキスト ボックス 169"/>
            <p:cNvSpPr txBox="1"/>
            <p:nvPr/>
          </p:nvSpPr>
          <p:spPr>
            <a:xfrm>
              <a:off x="225464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1" name="グループ化 170"/>
          <p:cNvGrpSpPr/>
          <p:nvPr/>
        </p:nvGrpSpPr>
        <p:grpSpPr>
          <a:xfrm>
            <a:off x="3125580" y="5612061"/>
            <a:ext cx="1513893" cy="261610"/>
            <a:chOff x="1001747" y="4343357"/>
            <a:chExt cx="1513893" cy="261610"/>
          </a:xfrm>
        </p:grpSpPr>
        <p:sp>
          <p:nvSpPr>
            <p:cNvPr id="172" name="テキスト ボックス 171"/>
            <p:cNvSpPr txBox="1"/>
            <p:nvPr/>
          </p:nvSpPr>
          <p:spPr>
            <a:xfrm>
              <a:off x="100174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テキスト ボックス 172"/>
            <p:cNvSpPr txBox="1"/>
            <p:nvPr/>
          </p:nvSpPr>
          <p:spPr>
            <a:xfrm>
              <a:off x="118073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テキスト ボックス 173"/>
            <p:cNvSpPr txBox="1"/>
            <p:nvPr/>
          </p:nvSpPr>
          <p:spPr>
            <a:xfrm>
              <a:off x="135971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テキスト ボックス 174"/>
            <p:cNvSpPr txBox="1"/>
            <p:nvPr/>
          </p:nvSpPr>
          <p:spPr>
            <a:xfrm>
              <a:off x="1538705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テキスト ボックス 175"/>
            <p:cNvSpPr txBox="1"/>
            <p:nvPr/>
          </p:nvSpPr>
          <p:spPr>
            <a:xfrm>
              <a:off x="1717691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テキスト ボックス 176"/>
            <p:cNvSpPr txBox="1"/>
            <p:nvPr/>
          </p:nvSpPr>
          <p:spPr>
            <a:xfrm>
              <a:off x="189667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テキスト ボックス 177"/>
            <p:cNvSpPr txBox="1"/>
            <p:nvPr/>
          </p:nvSpPr>
          <p:spPr>
            <a:xfrm>
              <a:off x="207566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テキスト ボックス 178"/>
            <p:cNvSpPr txBox="1"/>
            <p:nvPr/>
          </p:nvSpPr>
          <p:spPr>
            <a:xfrm>
              <a:off x="225464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0" name="グループ化 179"/>
          <p:cNvGrpSpPr/>
          <p:nvPr/>
        </p:nvGrpSpPr>
        <p:grpSpPr>
          <a:xfrm>
            <a:off x="5249420" y="5639769"/>
            <a:ext cx="1513893" cy="261610"/>
            <a:chOff x="1001747" y="4343357"/>
            <a:chExt cx="1513893" cy="261610"/>
          </a:xfrm>
        </p:grpSpPr>
        <p:sp>
          <p:nvSpPr>
            <p:cNvPr id="181" name="テキスト ボックス 180"/>
            <p:cNvSpPr txBox="1"/>
            <p:nvPr/>
          </p:nvSpPr>
          <p:spPr>
            <a:xfrm>
              <a:off x="100174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テキスト ボックス 181"/>
            <p:cNvSpPr txBox="1"/>
            <p:nvPr/>
          </p:nvSpPr>
          <p:spPr>
            <a:xfrm>
              <a:off x="118073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テキスト ボックス 182"/>
            <p:cNvSpPr txBox="1"/>
            <p:nvPr/>
          </p:nvSpPr>
          <p:spPr>
            <a:xfrm>
              <a:off x="135971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テキスト ボックス 183"/>
            <p:cNvSpPr txBox="1"/>
            <p:nvPr/>
          </p:nvSpPr>
          <p:spPr>
            <a:xfrm>
              <a:off x="1538705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テキスト ボックス 184"/>
            <p:cNvSpPr txBox="1"/>
            <p:nvPr/>
          </p:nvSpPr>
          <p:spPr>
            <a:xfrm>
              <a:off x="1717691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テキスト ボックス 185"/>
            <p:cNvSpPr txBox="1"/>
            <p:nvPr/>
          </p:nvSpPr>
          <p:spPr>
            <a:xfrm>
              <a:off x="189667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テキスト ボックス 186"/>
            <p:cNvSpPr txBox="1"/>
            <p:nvPr/>
          </p:nvSpPr>
          <p:spPr>
            <a:xfrm>
              <a:off x="207566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テキスト ボックス 187"/>
            <p:cNvSpPr txBox="1"/>
            <p:nvPr/>
          </p:nvSpPr>
          <p:spPr>
            <a:xfrm>
              <a:off x="225464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9" name="グループ化 188"/>
          <p:cNvGrpSpPr/>
          <p:nvPr/>
        </p:nvGrpSpPr>
        <p:grpSpPr>
          <a:xfrm>
            <a:off x="3107418" y="1194863"/>
            <a:ext cx="1513893" cy="261610"/>
            <a:chOff x="1001747" y="4343357"/>
            <a:chExt cx="1513893" cy="261610"/>
          </a:xfrm>
        </p:grpSpPr>
        <p:sp>
          <p:nvSpPr>
            <p:cNvPr id="190" name="テキスト ボックス 189"/>
            <p:cNvSpPr txBox="1"/>
            <p:nvPr/>
          </p:nvSpPr>
          <p:spPr>
            <a:xfrm>
              <a:off x="100174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テキスト ボックス 190"/>
            <p:cNvSpPr txBox="1"/>
            <p:nvPr/>
          </p:nvSpPr>
          <p:spPr>
            <a:xfrm>
              <a:off x="118073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テキスト ボックス 191"/>
            <p:cNvSpPr txBox="1"/>
            <p:nvPr/>
          </p:nvSpPr>
          <p:spPr>
            <a:xfrm>
              <a:off x="135971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テキスト ボックス 192"/>
            <p:cNvSpPr txBox="1"/>
            <p:nvPr/>
          </p:nvSpPr>
          <p:spPr>
            <a:xfrm>
              <a:off x="1538705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テキスト ボックス 193"/>
            <p:cNvSpPr txBox="1"/>
            <p:nvPr/>
          </p:nvSpPr>
          <p:spPr>
            <a:xfrm>
              <a:off x="1717691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テキスト ボックス 194"/>
            <p:cNvSpPr txBox="1"/>
            <p:nvPr/>
          </p:nvSpPr>
          <p:spPr>
            <a:xfrm>
              <a:off x="189667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テキスト ボックス 195"/>
            <p:cNvSpPr txBox="1"/>
            <p:nvPr/>
          </p:nvSpPr>
          <p:spPr>
            <a:xfrm>
              <a:off x="207566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テキスト ボックス 196"/>
            <p:cNvSpPr txBox="1"/>
            <p:nvPr/>
          </p:nvSpPr>
          <p:spPr>
            <a:xfrm>
              <a:off x="225464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8" name="グループ化 197"/>
          <p:cNvGrpSpPr/>
          <p:nvPr/>
        </p:nvGrpSpPr>
        <p:grpSpPr>
          <a:xfrm>
            <a:off x="5248139" y="1198749"/>
            <a:ext cx="1513893" cy="261610"/>
            <a:chOff x="1001747" y="4343357"/>
            <a:chExt cx="1513893" cy="261610"/>
          </a:xfrm>
        </p:grpSpPr>
        <p:sp>
          <p:nvSpPr>
            <p:cNvPr id="199" name="テキスト ボックス 198"/>
            <p:cNvSpPr txBox="1"/>
            <p:nvPr/>
          </p:nvSpPr>
          <p:spPr>
            <a:xfrm>
              <a:off x="100174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テキスト ボックス 199"/>
            <p:cNvSpPr txBox="1"/>
            <p:nvPr/>
          </p:nvSpPr>
          <p:spPr>
            <a:xfrm>
              <a:off x="118073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テキスト ボックス 200"/>
            <p:cNvSpPr txBox="1"/>
            <p:nvPr/>
          </p:nvSpPr>
          <p:spPr>
            <a:xfrm>
              <a:off x="135971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テキスト ボックス 201"/>
            <p:cNvSpPr txBox="1"/>
            <p:nvPr/>
          </p:nvSpPr>
          <p:spPr>
            <a:xfrm>
              <a:off x="1538705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テキスト ボックス 202"/>
            <p:cNvSpPr txBox="1"/>
            <p:nvPr/>
          </p:nvSpPr>
          <p:spPr>
            <a:xfrm>
              <a:off x="1717691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テキスト ボックス 203"/>
            <p:cNvSpPr txBox="1"/>
            <p:nvPr/>
          </p:nvSpPr>
          <p:spPr>
            <a:xfrm>
              <a:off x="189667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テキスト ボックス 204"/>
            <p:cNvSpPr txBox="1"/>
            <p:nvPr/>
          </p:nvSpPr>
          <p:spPr>
            <a:xfrm>
              <a:off x="207566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テキスト ボックス 205"/>
            <p:cNvSpPr txBox="1"/>
            <p:nvPr/>
          </p:nvSpPr>
          <p:spPr>
            <a:xfrm>
              <a:off x="225464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7" name="グループ化 206"/>
          <p:cNvGrpSpPr/>
          <p:nvPr/>
        </p:nvGrpSpPr>
        <p:grpSpPr>
          <a:xfrm>
            <a:off x="7355165" y="1171956"/>
            <a:ext cx="1513893" cy="261610"/>
            <a:chOff x="1001747" y="4343357"/>
            <a:chExt cx="1513893" cy="261610"/>
          </a:xfrm>
        </p:grpSpPr>
        <p:sp>
          <p:nvSpPr>
            <p:cNvPr id="208" name="テキスト ボックス 207"/>
            <p:cNvSpPr txBox="1"/>
            <p:nvPr/>
          </p:nvSpPr>
          <p:spPr>
            <a:xfrm>
              <a:off x="100174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テキスト ボックス 208"/>
            <p:cNvSpPr txBox="1"/>
            <p:nvPr/>
          </p:nvSpPr>
          <p:spPr>
            <a:xfrm>
              <a:off x="118073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テキスト ボックス 209"/>
            <p:cNvSpPr txBox="1"/>
            <p:nvPr/>
          </p:nvSpPr>
          <p:spPr>
            <a:xfrm>
              <a:off x="135971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テキスト ボックス 210"/>
            <p:cNvSpPr txBox="1"/>
            <p:nvPr/>
          </p:nvSpPr>
          <p:spPr>
            <a:xfrm>
              <a:off x="1538705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テキスト ボックス 211"/>
            <p:cNvSpPr txBox="1"/>
            <p:nvPr/>
          </p:nvSpPr>
          <p:spPr>
            <a:xfrm>
              <a:off x="1717691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テキスト ボックス 212"/>
            <p:cNvSpPr txBox="1"/>
            <p:nvPr/>
          </p:nvSpPr>
          <p:spPr>
            <a:xfrm>
              <a:off x="189667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テキスト ボックス 213"/>
            <p:cNvSpPr txBox="1"/>
            <p:nvPr/>
          </p:nvSpPr>
          <p:spPr>
            <a:xfrm>
              <a:off x="207566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テキスト ボックス 214"/>
            <p:cNvSpPr txBox="1"/>
            <p:nvPr/>
          </p:nvSpPr>
          <p:spPr>
            <a:xfrm>
              <a:off x="225464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6" name="テキスト ボックス 215"/>
          <p:cNvSpPr txBox="1"/>
          <p:nvPr/>
        </p:nvSpPr>
        <p:spPr>
          <a:xfrm>
            <a:off x="7122262" y="5445524"/>
            <a:ext cx="5430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11</a:t>
            </a:r>
            <a:endParaRPr lang="ja-JP" alt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正方形/長方形 216"/>
          <p:cNvSpPr/>
          <p:nvPr/>
        </p:nvSpPr>
        <p:spPr>
          <a:xfrm>
            <a:off x="174087" y="3049314"/>
            <a:ext cx="1994522" cy="32316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 smtClean="0">
                <a:cs typeface="Arial" panose="020B0604020202020204" pitchFamily="34" charset="0"/>
              </a:rPr>
              <a:t>Figure S2</a:t>
            </a:r>
            <a:r>
              <a:rPr lang="en-US" altLang="ja-JP" sz="1200" b="1" dirty="0">
                <a:cs typeface="Arial" panose="020B0604020202020204" pitchFamily="34" charset="0"/>
              </a:rPr>
              <a:t>. </a:t>
            </a:r>
            <a:r>
              <a:rPr lang="en-US" altLang="ja-JP" sz="1200" dirty="0"/>
              <a:t>Primer positions (arrows) for sequencing and amplification of DNA samples from a set of </a:t>
            </a:r>
            <a:r>
              <a:rPr lang="en-US" altLang="ja-JP" sz="1200" dirty="0" err="1"/>
              <a:t>nullisomic-tetrasomic</a:t>
            </a:r>
            <a:r>
              <a:rPr lang="en-US" altLang="ja-JP" sz="1200" dirty="0"/>
              <a:t> (NT) </a:t>
            </a:r>
            <a:r>
              <a:rPr lang="en-US" altLang="ja-JP" sz="1200" dirty="0" smtClean="0"/>
              <a:t>lines [19] </a:t>
            </a:r>
            <a:r>
              <a:rPr lang="en-US" altLang="ja-JP" sz="1200" dirty="0"/>
              <a:t>of CS for </a:t>
            </a:r>
            <a:r>
              <a:rPr lang="en-US" altLang="ja-JP" sz="1200" dirty="0" err="1"/>
              <a:t>homeologous</a:t>
            </a:r>
            <a:r>
              <a:rPr lang="en-US" altLang="ja-JP" sz="1200" dirty="0"/>
              <a:t> group 5 chromosomes. Numbers show accessions: 1. CS; 2. N5AT5B; 3. N5AT5D; 4. N5BT5A; 5. N5BT5D; 6. N5DT5B; 7. </a:t>
            </a:r>
            <a:r>
              <a:rPr lang="en-US" altLang="ja-JP" sz="1200" dirty="0" err="1"/>
              <a:t>Kitahonami</a:t>
            </a:r>
            <a:r>
              <a:rPr lang="en-US" altLang="ja-JP" sz="1200" dirty="0"/>
              <a:t>; 8. </a:t>
            </a:r>
            <a:r>
              <a:rPr lang="en-US" altLang="ja-JP" sz="1200" dirty="0" err="1"/>
              <a:t>Haruyo</a:t>
            </a:r>
            <a:r>
              <a:rPr lang="en-US" altLang="ja-JP" sz="1200" dirty="0"/>
              <a:t> Koi. Red line with marker name is a position for primer amplification corresponding to Table </a:t>
            </a:r>
            <a:r>
              <a:rPr lang="en-US" altLang="ja-JP" sz="1200" dirty="0" smtClean="0"/>
              <a:t>S1.</a:t>
            </a:r>
            <a:endParaRPr lang="ja-JP" altLang="en-US" sz="1200" dirty="0">
              <a:cs typeface="Arial" panose="020B0604020202020204" pitchFamily="34" charset="0"/>
            </a:endParaRPr>
          </a:p>
        </p:txBody>
      </p:sp>
      <p:grpSp>
        <p:nvGrpSpPr>
          <p:cNvPr id="221" name="グループ化 220"/>
          <p:cNvGrpSpPr/>
          <p:nvPr/>
        </p:nvGrpSpPr>
        <p:grpSpPr>
          <a:xfrm>
            <a:off x="7176179" y="5606413"/>
            <a:ext cx="1513893" cy="261610"/>
            <a:chOff x="1001747" y="4343357"/>
            <a:chExt cx="1513893" cy="261610"/>
          </a:xfrm>
        </p:grpSpPr>
        <p:sp>
          <p:nvSpPr>
            <p:cNvPr id="222" name="テキスト ボックス 221"/>
            <p:cNvSpPr txBox="1"/>
            <p:nvPr/>
          </p:nvSpPr>
          <p:spPr>
            <a:xfrm>
              <a:off x="100174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テキスト ボックス 222"/>
            <p:cNvSpPr txBox="1"/>
            <p:nvPr/>
          </p:nvSpPr>
          <p:spPr>
            <a:xfrm>
              <a:off x="118073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テキスト ボックス 223"/>
            <p:cNvSpPr txBox="1"/>
            <p:nvPr/>
          </p:nvSpPr>
          <p:spPr>
            <a:xfrm>
              <a:off x="135971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テキスト ボックス 224"/>
            <p:cNvSpPr txBox="1"/>
            <p:nvPr/>
          </p:nvSpPr>
          <p:spPr>
            <a:xfrm>
              <a:off x="1538705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テキスト ボックス 225"/>
            <p:cNvSpPr txBox="1"/>
            <p:nvPr/>
          </p:nvSpPr>
          <p:spPr>
            <a:xfrm>
              <a:off x="1717691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テキスト ボックス 226"/>
            <p:cNvSpPr txBox="1"/>
            <p:nvPr/>
          </p:nvSpPr>
          <p:spPr>
            <a:xfrm>
              <a:off x="1896677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テキスト ボックス 227"/>
            <p:cNvSpPr txBox="1"/>
            <p:nvPr/>
          </p:nvSpPr>
          <p:spPr>
            <a:xfrm>
              <a:off x="2075663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テキスト ボックス 228"/>
            <p:cNvSpPr txBox="1"/>
            <p:nvPr/>
          </p:nvSpPr>
          <p:spPr>
            <a:xfrm>
              <a:off x="2254649" y="4343357"/>
              <a:ext cx="260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0" name="グループ化 229"/>
          <p:cNvGrpSpPr/>
          <p:nvPr/>
        </p:nvGrpSpPr>
        <p:grpSpPr>
          <a:xfrm>
            <a:off x="7056381" y="5859079"/>
            <a:ext cx="1655463" cy="655170"/>
            <a:chOff x="3540125" y="2957513"/>
            <a:chExt cx="2378667" cy="941387"/>
          </a:xfrm>
        </p:grpSpPr>
        <p:pic>
          <p:nvPicPr>
            <p:cNvPr id="231" name="Picture 2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40125" y="2957513"/>
              <a:ext cx="2063750" cy="9413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2" name="Picture 3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7805" y="2959100"/>
              <a:ext cx="280987" cy="939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233" name="グループ化 232"/>
          <p:cNvGrpSpPr/>
          <p:nvPr/>
        </p:nvGrpSpPr>
        <p:grpSpPr>
          <a:xfrm>
            <a:off x="7413496" y="5785964"/>
            <a:ext cx="907156" cy="870685"/>
            <a:chOff x="1661423" y="3717032"/>
            <a:chExt cx="1578277" cy="3096000"/>
          </a:xfrm>
        </p:grpSpPr>
        <p:cxnSp>
          <p:nvCxnSpPr>
            <p:cNvPr id="234" name="直線コネクタ 233"/>
            <p:cNvCxnSpPr/>
            <p:nvPr/>
          </p:nvCxnSpPr>
          <p:spPr>
            <a:xfrm>
              <a:off x="1661423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直線コネクタ 234"/>
            <p:cNvCxnSpPr/>
            <p:nvPr/>
          </p:nvCxnSpPr>
          <p:spPr>
            <a:xfrm>
              <a:off x="2288640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直線コネクタ 235"/>
            <p:cNvCxnSpPr/>
            <p:nvPr/>
          </p:nvCxnSpPr>
          <p:spPr>
            <a:xfrm>
              <a:off x="2939734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直線コネクタ 236"/>
            <p:cNvCxnSpPr/>
            <p:nvPr/>
          </p:nvCxnSpPr>
          <p:spPr>
            <a:xfrm>
              <a:off x="3239700" y="3717032"/>
              <a:ext cx="0" cy="3096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82932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6801430"/>
              </p:ext>
            </p:extLst>
          </p:nvPr>
        </p:nvGraphicFramePr>
        <p:xfrm>
          <a:off x="971600" y="548680"/>
          <a:ext cx="3240360" cy="2520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827583" y="44624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 smtClean="0"/>
              <a:t>TaA</a:t>
            </a:r>
            <a:endParaRPr lang="ja-JP" altLang="en-US" sz="1400" i="1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292079" y="44625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 smtClean="0"/>
              <a:t>T</a:t>
            </a:r>
            <a:r>
              <a:rPr lang="en-US" altLang="ja-JP" sz="1400" i="1" dirty="0" err="1"/>
              <a:t>a</a:t>
            </a:r>
            <a:r>
              <a:rPr lang="en-US" altLang="ja-JP" sz="1400" i="1" dirty="0" err="1" smtClean="0"/>
              <a:t>B</a:t>
            </a:r>
            <a:endParaRPr lang="ja-JP" altLang="en-US" sz="1400" i="1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83567" y="3228520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 smtClean="0"/>
              <a:t>TaD</a:t>
            </a:r>
            <a:endParaRPr lang="ja-JP" altLang="en-US" sz="1400" i="1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364088" y="3284985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/>
              <a:t>Actin</a:t>
            </a:r>
            <a:endParaRPr lang="ja-JP" altLang="en-US" sz="1400" i="1" dirty="0"/>
          </a:p>
        </p:txBody>
      </p:sp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4293395"/>
              </p:ext>
            </p:extLst>
          </p:nvPr>
        </p:nvGraphicFramePr>
        <p:xfrm>
          <a:off x="5652120" y="466058"/>
          <a:ext cx="3168352" cy="26062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8094184"/>
              </p:ext>
            </p:extLst>
          </p:nvPr>
        </p:nvGraphicFramePr>
        <p:xfrm>
          <a:off x="1043607" y="3463221"/>
          <a:ext cx="3240360" cy="27114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9312350"/>
              </p:ext>
            </p:extLst>
          </p:nvPr>
        </p:nvGraphicFramePr>
        <p:xfrm>
          <a:off x="5859701" y="3688415"/>
          <a:ext cx="3082713" cy="2476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1907703" y="3090020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 copy numbe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644973" y="3090021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 copy numbe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907703" y="6203247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 copy numbe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876255" y="6203247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 copy numbe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-72519" y="1556792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-53982" y="4622649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4746503" y="4694657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4632931" y="1454297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301454" y="6381846"/>
            <a:ext cx="86409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/>
              <a:t>Figure S4</a:t>
            </a:r>
            <a:r>
              <a:rPr lang="en-US" altLang="ja-JP" sz="1400" b="1" dirty="0"/>
              <a:t>. </a:t>
            </a:r>
            <a:r>
              <a:rPr lang="en-US" altLang="ja-JP" sz="1400" dirty="0"/>
              <a:t>The plot of the log copy number versus threshold cycle (Ct) and the regression line for the expression of </a:t>
            </a:r>
            <a:r>
              <a:rPr lang="en-US" altLang="ja-JP" sz="1400" i="1" dirty="0"/>
              <a:t>Qsd1</a:t>
            </a:r>
            <a:r>
              <a:rPr lang="en-US" altLang="ja-JP" sz="1400" dirty="0"/>
              <a:t> from </a:t>
            </a:r>
            <a:r>
              <a:rPr lang="en-US" altLang="ja-JP" sz="1400" dirty="0" smtClean="0"/>
              <a:t>cv. Chinese </a:t>
            </a:r>
            <a:r>
              <a:rPr lang="en-US" altLang="ja-JP" sz="1400" dirty="0"/>
              <a:t>Spring shown in Fig. 2.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546520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965A3D3-F279-4447-A508-232CE1BDE9EF}" type="slidenum">
              <a:rPr lang="en-US" altLang="ja-JP" smtClean="0"/>
              <a:pPr>
                <a:defRPr/>
              </a:pPr>
              <a:t>4</a:t>
            </a:fld>
            <a:endParaRPr lang="en-US" altLang="ja-JP" dirty="0"/>
          </a:p>
        </p:txBody>
      </p:sp>
      <p:sp>
        <p:nvSpPr>
          <p:cNvPr id="4" name="正方形/長方形 3"/>
          <p:cNvSpPr/>
          <p:nvPr/>
        </p:nvSpPr>
        <p:spPr>
          <a:xfrm>
            <a:off x="251520" y="6093296"/>
            <a:ext cx="828092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/>
              <a:t>Figure S5. </a:t>
            </a:r>
            <a:r>
              <a:rPr lang="en-US" altLang="ja-JP" sz="1400" dirty="0" smtClean="0"/>
              <a:t>Expression </a:t>
            </a:r>
            <a:r>
              <a:rPr lang="en-US" altLang="ja-JP" sz="1400" dirty="0"/>
              <a:t>levels of </a:t>
            </a:r>
            <a:r>
              <a:rPr lang="en-US" altLang="ja-JP" sz="1400" i="1" dirty="0"/>
              <a:t>Qsd1</a:t>
            </a:r>
            <a:r>
              <a:rPr lang="en-US" altLang="ja-JP" sz="1400" dirty="0"/>
              <a:t> relative to </a:t>
            </a:r>
            <a:r>
              <a:rPr lang="en-US" altLang="ja-JP" sz="1400" i="1" dirty="0"/>
              <a:t>Actin</a:t>
            </a:r>
            <a:r>
              <a:rPr lang="en-US" altLang="ja-JP" sz="1400" dirty="0"/>
              <a:t> in embryos at 28 d after flowering. Error bars represent standard error, n = 3.</a:t>
            </a:r>
            <a:endParaRPr lang="ja-JP" altLang="en-US" dirty="0"/>
          </a:p>
        </p:txBody>
      </p:sp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6914827"/>
              </p:ext>
            </p:extLst>
          </p:nvPr>
        </p:nvGraphicFramePr>
        <p:xfrm>
          <a:off x="755576" y="476672"/>
          <a:ext cx="6984776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2267744" y="5547775"/>
            <a:ext cx="50405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ja-JP" sz="1400" i="1" dirty="0" smtClean="0">
                <a:ea typeface="ＭＳ 明朝" panose="02020609040205080304" pitchFamily="17" charset="-128"/>
                <a:cs typeface="Arial" panose="020B0604020202020204" pitchFamily="34" charset="0"/>
              </a:rPr>
              <a:t>T. </a:t>
            </a:r>
            <a:r>
              <a:rPr lang="en-US" altLang="ja-JP" sz="1400" i="1" dirty="0" err="1" smtClean="0">
                <a:ea typeface="ＭＳ 明朝" panose="02020609040205080304" pitchFamily="17" charset="-128"/>
                <a:cs typeface="Arial" panose="020B0604020202020204" pitchFamily="34" charset="0"/>
              </a:rPr>
              <a:t>monococcum</a:t>
            </a:r>
            <a:r>
              <a:rPr lang="en-US" altLang="ja-JP" sz="1400" i="1" dirty="0" smtClean="0">
                <a:ea typeface="ＭＳ 明朝" panose="02020609040205080304" pitchFamily="17" charset="-128"/>
                <a:cs typeface="Arial" panose="020B0604020202020204" pitchFamily="34" charset="0"/>
              </a:rPr>
              <a:t>               T. </a:t>
            </a:r>
            <a:r>
              <a:rPr lang="en-US" altLang="ja-JP" sz="1400" i="1" dirty="0" err="1" smtClean="0">
                <a:ea typeface="ＭＳ 明朝" panose="02020609040205080304" pitchFamily="17" charset="-128"/>
                <a:cs typeface="Arial" panose="020B0604020202020204" pitchFamily="34" charset="0"/>
              </a:rPr>
              <a:t>boeoticum</a:t>
            </a:r>
            <a:r>
              <a:rPr lang="en-US" altLang="ja-JP" sz="1400" i="1" dirty="0" smtClean="0">
                <a:ea typeface="ＭＳ 明朝" panose="02020609040205080304" pitchFamily="17" charset="-128"/>
                <a:cs typeface="Arial" panose="020B0604020202020204" pitchFamily="34" charset="0"/>
              </a:rPr>
              <a:t>                       </a:t>
            </a:r>
            <a:r>
              <a:rPr lang="en-US" altLang="ja-JP" sz="1400" dirty="0" smtClean="0">
                <a:ea typeface="ＭＳ 明朝" panose="02020609040205080304" pitchFamily="17" charset="-128"/>
                <a:cs typeface="Arial" panose="020B0604020202020204" pitchFamily="34" charset="0"/>
              </a:rPr>
              <a:t>RIL56</a:t>
            </a:r>
            <a:endParaRPr lang="ja-JP" altLang="ja-JP" sz="1400" kern="100" dirty="0">
              <a:effectLst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20306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3983402"/>
              </p:ext>
            </p:extLst>
          </p:nvPr>
        </p:nvGraphicFramePr>
        <p:xfrm>
          <a:off x="139700" y="2269729"/>
          <a:ext cx="3800475" cy="27277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直線コネクタ 2"/>
          <p:cNvCxnSpPr/>
          <p:nvPr/>
        </p:nvCxnSpPr>
        <p:spPr>
          <a:xfrm>
            <a:off x="1866900" y="2724150"/>
            <a:ext cx="1676400" cy="14605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正方形/長方形 1"/>
          <p:cNvSpPr/>
          <p:nvPr/>
        </p:nvSpPr>
        <p:spPr>
          <a:xfrm>
            <a:off x="395536" y="5451872"/>
            <a:ext cx="840137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/>
              <a:t>Figure S6</a:t>
            </a:r>
            <a:r>
              <a:rPr lang="en-US" altLang="ja-JP" sz="1400" b="1" dirty="0"/>
              <a:t>. </a:t>
            </a:r>
            <a:r>
              <a:rPr lang="en-US" altLang="ja-JP" sz="1400" dirty="0"/>
              <a:t>The plot of the log copy number versus threshold cycle (Ct) and the regression line for the expression of </a:t>
            </a:r>
            <a:r>
              <a:rPr lang="en-US" altLang="ja-JP" sz="1400" i="1" dirty="0"/>
              <a:t>Qsd1</a:t>
            </a:r>
            <a:r>
              <a:rPr lang="en-US" altLang="ja-JP" sz="1400" dirty="0"/>
              <a:t> in diploid wheat accessions shown in Fig. </a:t>
            </a:r>
            <a:r>
              <a:rPr lang="en-US" altLang="ja-JP" sz="1400" dirty="0" smtClean="0"/>
              <a:t>S5.</a:t>
            </a:r>
            <a:endParaRPr lang="ja-JP" altLang="en-US" sz="1400" dirty="0"/>
          </a:p>
        </p:txBody>
      </p:sp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9277835"/>
              </p:ext>
            </p:extLst>
          </p:nvPr>
        </p:nvGraphicFramePr>
        <p:xfrm>
          <a:off x="3940175" y="2268651"/>
          <a:ext cx="3801600" cy="27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テキスト ボックス 10"/>
          <p:cNvSpPr txBox="1"/>
          <p:nvPr/>
        </p:nvSpPr>
        <p:spPr bwMode="auto">
          <a:xfrm>
            <a:off x="4889182" y="3709951"/>
            <a:ext cx="1556385" cy="474699"/>
          </a:xfrm>
          <a:prstGeom prst="rect">
            <a:avLst/>
          </a:prstGeom>
          <a:solidFill>
            <a:sysClr val="window" lastClr="FFFFFF"/>
          </a:solidFill>
          <a:ln w="9525" cmpd="sng">
            <a:noFill/>
          </a:ln>
          <a:effectLst/>
        </p:spPr>
        <p:txBody>
          <a:bodyPr wrap="square" rtlCol="0" anchor="t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y = -3.37347x + 36.17181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R2 = 0.999738</a:t>
            </a:r>
            <a:endParaRPr kumimoji="1" lang="ja-JP" altLang="en-US" sz="900" b="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378647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965A3D3-F279-4447-A508-232CE1BDE9EF}" type="slidenum">
              <a:rPr lang="en-US" altLang="ja-JP" smtClean="0"/>
              <a:pPr>
                <a:defRPr/>
              </a:pPr>
              <a:t>6</a:t>
            </a:fld>
            <a:endParaRPr lang="en-US" altLang="ja-JP"/>
          </a:p>
        </p:txBody>
      </p:sp>
      <p:sp>
        <p:nvSpPr>
          <p:cNvPr id="4" name="正方形/長方形 3"/>
          <p:cNvSpPr/>
          <p:nvPr/>
        </p:nvSpPr>
        <p:spPr>
          <a:xfrm>
            <a:off x="395536" y="6151632"/>
            <a:ext cx="784887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/>
              <a:t>Figure S7</a:t>
            </a:r>
            <a:r>
              <a:rPr lang="en-US" altLang="ja-JP" sz="1400" b="1" dirty="0"/>
              <a:t>. </a:t>
            </a:r>
            <a:r>
              <a:rPr lang="en-US" altLang="ja-JP" sz="1400" dirty="0"/>
              <a:t>Comparison of Qsd1 orthologous amino acid sequences in wheat and barley. Asterisks indicate no substitution among the materials.</a:t>
            </a:r>
            <a:endParaRPr lang="ja-JP" altLang="en-US" sz="1400" dirty="0"/>
          </a:p>
        </p:txBody>
      </p:sp>
      <p:sp>
        <p:nvSpPr>
          <p:cNvPr id="3" name="正方形/長方形 2"/>
          <p:cNvSpPr/>
          <p:nvPr/>
        </p:nvSpPr>
        <p:spPr>
          <a:xfrm>
            <a:off x="345604" y="73045"/>
            <a:ext cx="6440388" cy="60785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N        MSYNKTASITAETINPKVKIFDYEPCGEIARHAERLEQEMEKSPGSRPFPEIIYCNLGNP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602      MSYNKTASITAETINPKVKIFDYEPCGEIARHAERLEQEMEKSPGSRPFPEIIYCNLGNP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MSYNKTASITAETINPKVKIFDYEPCGEIARHAERLEQEMEKSPGSRPFPEITYCNLGNP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b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MSYNKTASITAETINPKVKIFDYEPCGEIARHAERLEQEMEKSPGSRPFPEITYCNLGNP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m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MSYNKTASITAETINPKVKIFDYEPCGEIARHAERLEQEMEKSPGSRPFPEITYCNLGNP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MSYNKTASITAETINPKVKIFDYEPCGEIARHAERLAQEMEKSPGSRPFPEITYCNLGNP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KH         MSYNKTASITAETINPKVKIFDYEPCGEIARHAERLEQEMEKSPGSRPFPEITYCNLGNP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D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MSYNKTASITAETINPKVKIFDYEPCGEIARHAERLEQEMEKSPGSRPFPEITYCNLGNP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   ************************************ *************** *******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 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N        QALGQRPITFFREVISLCDNPALLHRDETRMLFSPCAINRARKIIESMPGRNTGAYTNSQ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602      QALGQRPITFFREVISLCDNPALLHRDETRMLFSPCAINRARKIIESMPGRNTGAYTNSQ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QALGQRPITFFREVLSLCDNPALLRRDETRMLFSPCAINRARKIIESMPGRNSGAYTNSQ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b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QALGQRPITFFREVLSLCDNPALLRRDETRMLFSPCAINRARKIIESMPGRNSGAYTNSQ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m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QALGQRPITFFREVLSLCDNPALLRRDETRMLFSPCAINRARKIIESMPGRNSGAYTNSQ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QALGQRPITFFREVLSLCDNPALLHRDETRMLFSPCAINRARKIIESMPGRNSGAYTNSQ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KH         QALGQRPITFFREVLSLCDNPALLHRDETRMLFSPCAINRARKIIESMPGRNSGAYTNNQ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D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QALGQRPITFFREVLSLCDNPALLRRDETRMLFSPCAINRARKIIESMPGRNSGAYTNSQ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  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************ ********* *************************** ***** *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 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N        GIRSLREAVASGIAARDGFPSRPEDIFLTDGASSAINLSMQILIRSQEDGILCPLPEYP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602      GIRSLREAVASGIAARDGFPSRPEDIFLTDGASSAINLSMQILIRSQEDGILCPLPEYP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GIRSLREAVASGIAARDGFPSRPEDIFLTDGASSAINLSMQILIRSQEDGVLCPLPEYP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b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GIRSLREAVASGIAARDGFPSRPEDIFLTDGASSAINLSMQILIRSQEDGVLCPLPEYP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m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GIRSLREAVASGIAARDGFPSRPEDIFLTDGASSAINLSMQILIRSQEDGVLCPLPEYP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GIRSLREAVANGIAARDGFPSRPEDIFLTDGASSAINLSMQILIRSQEDGILCPLPEYP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KH         GIRSLREAVANGIAARDGFPSRPEDIFLTDGASSAINLSMQILIRSQEDGILCPLPEYP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D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GIRSLREAVASGIAARDGFPSRPEDIFLTDGASSAINLSMQILIRSQEDGVLCPLPEYP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  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******** *************************************** *********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 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N        YSASIILHGGTMVPYNLSEDGDWGLEIFEVKRCFEEARIAGLTVRAMVIINPGNPTGQV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602      YSASIILHGGTMVPYNLSEDGDWGLEIFEVKRCLEEARIAGLTVRAMVIINPGNPTGQV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YSASIILHGGTMVPYNLSEDGDWGLEIFEVKRCLEEARIAGLTVRAMVIINPGNPTGQV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b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YSASIILHGGTMVPYNLSEDGDWGLEIFEVKRCLEEARIAGLTVRAMVIINPGNPTGQV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m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YSASIILHGGTMVPYNLSEDGDWGLEIFEVKRCLEEARIAGLTVRAMVIINPGNPTGQV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YSASIILHGGTMVPYNLSEDGDWGLEIFEVKRCLEEARIAGLTVRAMVIINPGNPTGQV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KH         YSASIILHGGTMVPYNLSEDGDWGLEIFEVKRCLEEARIAGLTVRAMVIINPGNPTGQV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D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YSASIILHGGTMVPYNLSEDGDWGLEIFEVKRCLEEARIAGLTVRAMVIINPGNPTGQVL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  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******************************* **************************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 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N        SVTNQEEIVEFCRKEGLVILADEVYQDNVYVEDRKFNSFKKVARSLGYDENDISIVSFH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602      SVTNQEEIVEFCRKEGLVILADEVYQDNVYVEDRKFNSFKKVARSLGCDENDISIVSFH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SITNQEEIVEFCRKEGLVMLADEVYQDNVYVEDRKFHSFKKVARSLGYDENDISIVSFH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b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SITNQEEIVEFCRKEGLVMLADEVYQDNVYVEDRKFHSFKKVARSLGYDENDISIVSFH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m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SITNQEEIVQFCRKEGLVMLADEVYQDNVYVEDRKFHSFKKVARSLGYDENDISIVSFH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SITNQEEIVEFCRKEGLVMLADEVYQDNVYVEDKKFHSFKKVARSLGYDENDISIVSFH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KH         SITNQEEIVEFCRKEGLVMLADEVYQDNVYVEDKKFHYFKKVARSLGYDENDISIVSFH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D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SVTNQEEIVEFCRKEGLVMLADEVYQDNVYVEDRKFHSFKKVARSLGYDENDISIVSFH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  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 ******* ******** ************** **  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******* ************</a:t>
            </a:r>
            <a:endParaRPr lang="ja-JP" alt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4427984" y="73045"/>
            <a:ext cx="4572000" cy="4862870"/>
          </a:xfrm>
          <a:prstGeom prst="rect">
            <a:avLst/>
          </a:prstGeom>
        </p:spPr>
        <p:txBody>
          <a:bodyPr>
            <a:spAutoFit/>
          </a:bodyPr>
          <a:lstStyle/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N        VSMGYSGECGRRGGYMEICGFGDDVMGEIRKVASVTLCPNTNGQILTSLAMDPPKLGDGC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602      VSMGYSGECGRRGGYMEICGFGDDVMGEIRKVASVTLCPNTNGQILTSLAMDPPKLGDGC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VSMGFSGECGRRGGYMEICGFGDDVMGEIRKVASVTLCPNIGGQILTSLAMDPPKLGDGC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b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VSMGFSGECGRRGGYMEICGFGDDVMGEIRKVASVTLCPNIGGQILTSLAMDPPKLGDGC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m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VSMGFSGECGRRGGYMEICGFGDDVMGEIRKVASVTLCPNIGGQILTSLAMDPPKLGDGC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VSMGFSGECGRRGGYMEICGFGDDVMGEIRKVASVTLCPNTSGQILTSLAMDPPKLGDGC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KH         VSMGFSGECGRRGGYMEICGFGDDVMGEIRKVASVTLCPNTSGQILTSLAMDPPKLGDGC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D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VSMGFSGECGRRGGYMEICGFGDDVMGEIRKVASVTLCPNIGGQILTSLAMDPPKLGDGC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  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** ***********************************  ******************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 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N        FEAFMAEKEEISTSLAKRAKTLVNAFSSLEGMTCNKVEGAIYAFPRIHLPAAAIKAAKAE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602      FEAFMAEKEETSTSLAKRAKTLVNAFSSLEGMTCNKVEGAIYAFPRIHLPAAAIKAAKAE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A</a:t>
            </a:r>
            <a:r>
              <a:rPr lang="en-US" altLang="ja-JP" sz="800" kern="0" dirty="0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FENFMAEKEDIRLSLAKRAKTLSSAFSSLEGMTCNKVEGAIYAFPRIHLPAAAIKAAKAE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bA</a:t>
            </a:r>
            <a:r>
              <a:rPr lang="en-US" altLang="ja-JP" sz="800" kern="0" dirty="0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FENFMAEKEDIRLSLAKRAKTLSSAFSSLEGMTCNKVEGAIYAFPRIHLPAAAIKAAKAE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mA</a:t>
            </a:r>
            <a:r>
              <a:rPr lang="en-US" altLang="ja-JP" sz="800" kern="0" dirty="0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FENFMAEKEDIRLSLAKRAKTLSSAFSSLEGMTCNKVEGAIYAFPRIHLPAAAIKAAKAE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FEDFMAEKEDIRLSLAKRAKTLASAFSSLEGMTCNKVEGAIYAFPRIHLPAAAIKAAKAE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KH         FEDFMAEKEDIRLSLAKRAKTLASAFSSLEGMTCNKVEGAIYAFPRIHLPAAAIKAAKAE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D</a:t>
            </a:r>
            <a:r>
              <a:rPr lang="en-US" altLang="ja-JP" sz="800" kern="0" dirty="0"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FENFMAEKEDIRLSLAK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RAKTLAGAFSSLEGMTCNRVEGAIYAFPRIHLPAAAIKAAKAE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   **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****    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*******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*********** ************************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 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N        DVSPDTFYACRLLDATGIAVVPGSGFHQISGRNTATGTWHIRCTILVAEDKIEAMIARLK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602      DMSPDTFYACRLLDATGIAVVPGSGFHQISGRNTATGTWHIRCTILVAEDKIEAMIARLK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GVSPDMFYACRLLDATGIAVVPGSGFHQVSGRNKATGTCHIRCTILPGEEKIKEMIPRLK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b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GVSPDMFYACRLLDATGIAVVPGSGFHQVSGRNKATGTCHIRCTILPGEEKIKEMIPRLK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m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GVSPDMFYACRLLDATGIAVVPGSGFHQVSGRNKATGTCHIRCTILPGEEKIKEMIPRLK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GMSPDMFYACRLLNATGIAVVPGSGFHQVSGRNKATGTWHIRCTILPGEDKIKAMIPRLK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KH         GMSPDMFYACRLLNATGIAVVPGSGFHQVSGRNKATGTWHIRCTILPGEDKIKAMIPRLK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D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GMSPDLFYACRLLDATGIAVVPGSGFHQVSGRNKATGTWHIRCTILPGEDKIKVMIPRLK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  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*** ******* ************** **** **** 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*****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* **  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 ***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 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N        AFHESFMNEFRDR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qsd1-H602      AFHESFMNEFRDR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EFHESFMNEFRDR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b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EFHESFMNEFRDR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mA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EFHESFMNEFRDR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EFHESFMNEFRNR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B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KH         EFHESFMNEFRNR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 err="1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TaD</a:t>
            </a: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-CS         EFHESFMNEFRDRS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05410" marR="105410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ja-JP" sz="800" kern="0" dirty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                </a:t>
            </a:r>
            <a:r>
              <a:rPr lang="en-US" altLang="ja-JP" sz="800" kern="0" dirty="0" smtClean="0">
                <a:solidFill>
                  <a:srgbClr val="222222"/>
                </a:solidFill>
                <a:latin typeface="ＭＳ ゴシック" panose="020B0609070205080204" pitchFamily="49" charset="-128"/>
                <a:ea typeface="ＭＳ 明朝" panose="02020609040205080304" pitchFamily="17" charset="-128"/>
                <a:cs typeface="Courier New" panose="02070309020205020404" pitchFamily="49" charset="0"/>
              </a:rPr>
              <a:t>********** **</a:t>
            </a:r>
            <a:endParaRPr lang="ja-JP" alt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8101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テキスト ボックス 140"/>
          <p:cNvSpPr txBox="1"/>
          <p:nvPr/>
        </p:nvSpPr>
        <p:spPr>
          <a:xfrm>
            <a:off x="521514" y="260648"/>
            <a:ext cx="8079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Table S1 </a:t>
            </a:r>
            <a:r>
              <a:rPr lang="en-US" altLang="ja-JP" dirty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Primers used for Chinese Spring BAC library selection.</a:t>
            </a:r>
            <a:endParaRPr lang="ja-JP" altLang="en-US" dirty="0">
              <a:solidFill>
                <a:schemeClr val="tx1">
                  <a:lumMod val="95000"/>
                  <a:lumOff val="5000"/>
                </a:schemeClr>
              </a:solidFill>
              <a:cs typeface="Arial" panose="020B0604020202020204" pitchFamily="34" charset="0"/>
            </a:endParaRP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629980"/>
            <a:ext cx="5800502" cy="59497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703156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テキスト ボックス 140"/>
          <p:cNvSpPr txBox="1"/>
          <p:nvPr/>
        </p:nvSpPr>
        <p:spPr>
          <a:xfrm>
            <a:off x="539552" y="332656"/>
            <a:ext cx="807992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Table S2 </a:t>
            </a:r>
            <a:r>
              <a:rPr lang="en-US" altLang="ja-JP" dirty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Primer information for polymorphism detection in the </a:t>
            </a:r>
            <a:r>
              <a:rPr lang="en-US" altLang="ja-JP" i="1" dirty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Qsd1</a:t>
            </a:r>
            <a:r>
              <a:rPr lang="en-US" altLang="ja-JP" dirty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 region. The position is based on the numbers from the 3' end of a barley cv. </a:t>
            </a:r>
            <a:r>
              <a:rPr lang="en-US" altLang="ja-JP" dirty="0" err="1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Haruna</a:t>
            </a:r>
            <a:r>
              <a:rPr lang="en-US" altLang="ja-JP" dirty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 </a:t>
            </a:r>
            <a:r>
              <a:rPr lang="en-US" altLang="ja-JP" dirty="0" err="1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Nijo</a:t>
            </a:r>
            <a:r>
              <a:rPr lang="en-US" altLang="ja-JP" dirty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 BAC clone </a:t>
            </a:r>
            <a:r>
              <a:rPr lang="en-US" altLang="ja-JP" dirty="0" smtClean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[9]. </a:t>
            </a:r>
            <a:r>
              <a:rPr lang="en-US" altLang="ja-JP" dirty="0" smtClean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Red character shows sequence in </a:t>
            </a:r>
            <a:r>
              <a:rPr lang="en-US" altLang="ja-JP" i="1" dirty="0" err="1" smtClean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Triticum</a:t>
            </a:r>
            <a:r>
              <a:rPr lang="en-US" altLang="ja-JP" i="1" dirty="0" smtClean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 </a:t>
            </a:r>
            <a:r>
              <a:rPr lang="en-US" altLang="ja-JP" i="1" dirty="0" err="1" smtClean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monococcum</a:t>
            </a:r>
            <a:r>
              <a:rPr lang="en-US" altLang="ja-JP" dirty="0" smtClean="0">
                <a:solidFill>
                  <a:schemeClr val="tx1">
                    <a:lumMod val="95000"/>
                    <a:lumOff val="5000"/>
                  </a:schemeClr>
                </a:solidFill>
                <a:cs typeface="Arial" panose="020B0604020202020204" pitchFamily="34" charset="0"/>
              </a:rPr>
              <a:t>.</a:t>
            </a:r>
            <a:endParaRPr lang="ja-JP" altLang="en-US" dirty="0">
              <a:solidFill>
                <a:schemeClr val="tx1">
                  <a:lumMod val="95000"/>
                  <a:lumOff val="5000"/>
                </a:schemeClr>
              </a:solidFill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6922942"/>
              </p:ext>
            </p:extLst>
          </p:nvPr>
        </p:nvGraphicFramePr>
        <p:xfrm>
          <a:off x="827584" y="1988840"/>
          <a:ext cx="7450883" cy="360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ワークシート" r:id="rId4" imgW="5958877" imgH="2880360" progId="Excel.Sheet.12">
                  <p:embed/>
                </p:oleObj>
              </mc:Choice>
              <mc:Fallback>
                <p:oleObj name="ワークシート" r:id="rId4" imgW="5958877" imgH="288036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27584" y="1988840"/>
                        <a:ext cx="7450883" cy="360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59811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524</TotalTime>
  <Words>563</Words>
  <Application>Microsoft Office PowerPoint</Application>
  <PresentationFormat>画面に合わせる (4:3)</PresentationFormat>
  <Paragraphs>244</Paragraphs>
  <Slides>8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10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20" baseType="lpstr">
      <vt:lpstr>Gulim</vt:lpstr>
      <vt:lpstr>ＭＳ Ｐゴシック</vt:lpstr>
      <vt:lpstr>ＭＳ Ｐ明朝</vt:lpstr>
      <vt:lpstr>ＭＳ ゴシック</vt:lpstr>
      <vt:lpstr>ＭＳ 明朝</vt:lpstr>
      <vt:lpstr>Arial</vt:lpstr>
      <vt:lpstr>Calibri</vt:lpstr>
      <vt:lpstr>Century</vt:lpstr>
      <vt:lpstr>Courier New</vt:lpstr>
      <vt:lpstr>Times New Roman</vt:lpstr>
      <vt:lpstr>Office ​​テーマ</vt:lpstr>
      <vt:lpstr>ワークシー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岡山大学資源生物科学研究所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hiro Sato</dc:creator>
  <cp:lastModifiedBy>sato</cp:lastModifiedBy>
  <cp:revision>498</cp:revision>
  <cp:lastPrinted>2017-01-24T08:54:29Z</cp:lastPrinted>
  <dcterms:created xsi:type="dcterms:W3CDTF">2005-03-16T05:45:19Z</dcterms:created>
  <dcterms:modified xsi:type="dcterms:W3CDTF">2017-03-09T01:17:21Z</dcterms:modified>
</cp:coreProperties>
</file>